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7" autoAdjust="0"/>
    <p:restoredTop sz="94477" autoAdjust="0"/>
  </p:normalViewPr>
  <p:slideViewPr>
    <p:cSldViewPr snapToGrid="0">
      <p:cViewPr varScale="1">
        <p:scale>
          <a:sx n="70" d="100"/>
          <a:sy n="70" d="100"/>
        </p:scale>
        <p:origin x="67" y="43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F5C392-04CC-408D-80B5-1D24120EF11F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54D9E5-F4D7-468B-8A8F-21CB7FCA7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484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54D9E5-F4D7-468B-8A8F-21CB7FCA709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024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839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665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75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226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536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466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68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48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936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741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627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4493B-6042-4D85-9663-300A2FEE1E87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FFB73-FBF4-4276-AD8D-6103E63A25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218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3.wdp"/><Relationship Id="rId5" Type="http://schemas.openxmlformats.org/officeDocument/2006/relationships/image" Target="../media/image2.png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2" name="Group 171"/>
          <p:cNvGrpSpPr/>
          <p:nvPr/>
        </p:nvGrpSpPr>
        <p:grpSpPr>
          <a:xfrm>
            <a:off x="269580" y="1583356"/>
            <a:ext cx="5815533" cy="3792577"/>
            <a:chOff x="4689181" y="2552193"/>
            <a:chExt cx="5815533" cy="379257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D42D0CC-88E7-413E-8BE9-A8ED2D389E90}"/>
                </a:ext>
              </a:extLst>
            </p:cNvPr>
            <p:cNvGrpSpPr/>
            <p:nvPr/>
          </p:nvGrpSpPr>
          <p:grpSpPr>
            <a:xfrm>
              <a:off x="7321418" y="2730352"/>
              <a:ext cx="3009124" cy="1114367"/>
              <a:chOff x="6828933" y="1687873"/>
              <a:chExt cx="3009124" cy="1114367"/>
            </a:xfrm>
          </p:grpSpPr>
          <p:sp>
            <p:nvSpPr>
              <p:cNvPr id="5" name="Oval 4">
                <a:extLst>
                  <a:ext uri="{FF2B5EF4-FFF2-40B4-BE49-F238E27FC236}">
                    <a16:creationId xmlns:a16="http://schemas.microsoft.com/office/drawing/2014/main" id="{1F6806E7-1388-4064-BEA7-B5BDFF831249}"/>
                  </a:ext>
                </a:extLst>
              </p:cNvPr>
              <p:cNvSpPr/>
              <p:nvPr/>
            </p:nvSpPr>
            <p:spPr>
              <a:xfrm>
                <a:off x="6828933" y="1758087"/>
                <a:ext cx="1156900" cy="1044153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Oval 5">
                <a:extLst>
                  <a:ext uri="{FF2B5EF4-FFF2-40B4-BE49-F238E27FC236}">
                    <a16:creationId xmlns:a16="http://schemas.microsoft.com/office/drawing/2014/main" id="{8CEF73C9-26AB-4362-A76B-4E1F10BBCCFD}"/>
                  </a:ext>
                </a:extLst>
              </p:cNvPr>
              <p:cNvSpPr/>
              <p:nvPr/>
            </p:nvSpPr>
            <p:spPr>
              <a:xfrm>
                <a:off x="6903600" y="1957212"/>
                <a:ext cx="466070" cy="541300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i="1" dirty="0"/>
              </a:p>
            </p:txBody>
          </p:sp>
          <p:sp>
            <p:nvSpPr>
              <p:cNvPr id="7" name="Freeform 130">
                <a:extLst>
                  <a:ext uri="{FF2B5EF4-FFF2-40B4-BE49-F238E27FC236}">
                    <a16:creationId xmlns:a16="http://schemas.microsoft.com/office/drawing/2014/main" id="{F59AC6D2-3C6D-46F3-BB90-D386D28500DB}"/>
                  </a:ext>
                </a:extLst>
              </p:cNvPr>
              <p:cNvSpPr/>
              <p:nvPr/>
            </p:nvSpPr>
            <p:spPr>
              <a:xfrm>
                <a:off x="7259668" y="1973151"/>
                <a:ext cx="206110" cy="579075"/>
              </a:xfrm>
              <a:custGeom>
                <a:avLst/>
                <a:gdLst>
                  <a:gd name="connsiteX0" fmla="*/ 140063 w 293078"/>
                  <a:gd name="connsiteY0" fmla="*/ 310 h 856094"/>
                  <a:gd name="connsiteX1" fmla="*/ 89729 w 293078"/>
                  <a:gd name="connsiteY1" fmla="*/ 59033 h 856094"/>
                  <a:gd name="connsiteX2" fmla="*/ 198786 w 293078"/>
                  <a:gd name="connsiteY2" fmla="*/ 142923 h 856094"/>
                  <a:gd name="connsiteX3" fmla="*/ 223953 w 293078"/>
                  <a:gd name="connsiteY3" fmla="*/ 453316 h 856094"/>
                  <a:gd name="connsiteX4" fmla="*/ 156841 w 293078"/>
                  <a:gd name="connsiteY4" fmla="*/ 621096 h 856094"/>
                  <a:gd name="connsiteX5" fmla="*/ 31006 w 293078"/>
                  <a:gd name="connsiteY5" fmla="*/ 763709 h 856094"/>
                  <a:gd name="connsiteX6" fmla="*/ 31006 w 293078"/>
                  <a:gd name="connsiteY6" fmla="*/ 763709 h 856094"/>
                  <a:gd name="connsiteX7" fmla="*/ 5839 w 293078"/>
                  <a:gd name="connsiteY7" fmla="*/ 855988 h 856094"/>
                  <a:gd name="connsiteX8" fmla="*/ 156841 w 293078"/>
                  <a:gd name="connsiteY8" fmla="*/ 780487 h 856094"/>
                  <a:gd name="connsiteX9" fmla="*/ 165230 w 293078"/>
                  <a:gd name="connsiteY9" fmla="*/ 704986 h 856094"/>
                  <a:gd name="connsiteX10" fmla="*/ 223953 w 293078"/>
                  <a:gd name="connsiteY10" fmla="*/ 570762 h 856094"/>
                  <a:gd name="connsiteX11" fmla="*/ 274287 w 293078"/>
                  <a:gd name="connsiteY11" fmla="*/ 394593 h 856094"/>
                  <a:gd name="connsiteX12" fmla="*/ 291065 w 293078"/>
                  <a:gd name="connsiteY12" fmla="*/ 268758 h 856094"/>
                  <a:gd name="connsiteX13" fmla="*/ 232342 w 293078"/>
                  <a:gd name="connsiteY13" fmla="*/ 126145 h 856094"/>
                  <a:gd name="connsiteX14" fmla="*/ 190397 w 293078"/>
                  <a:gd name="connsiteY14" fmla="*/ 8699 h 856094"/>
                  <a:gd name="connsiteX15" fmla="*/ 89729 w 293078"/>
                  <a:gd name="connsiteY15" fmla="*/ 8699 h 856094"/>
                  <a:gd name="connsiteX16" fmla="*/ 89729 w 293078"/>
                  <a:gd name="connsiteY16" fmla="*/ 8699 h 8560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293078" h="856094">
                    <a:moveTo>
                      <a:pt x="140063" y="310"/>
                    </a:moveTo>
                    <a:cubicBezTo>
                      <a:pt x="110002" y="17787"/>
                      <a:pt x="79942" y="35264"/>
                      <a:pt x="89729" y="59033"/>
                    </a:cubicBezTo>
                    <a:cubicBezTo>
                      <a:pt x="99516" y="82802"/>
                      <a:pt x="176415" y="77209"/>
                      <a:pt x="198786" y="142923"/>
                    </a:cubicBezTo>
                    <a:cubicBezTo>
                      <a:pt x="221157" y="208637"/>
                      <a:pt x="230944" y="373621"/>
                      <a:pt x="223953" y="453316"/>
                    </a:cubicBezTo>
                    <a:cubicBezTo>
                      <a:pt x="216962" y="533011"/>
                      <a:pt x="188999" y="569364"/>
                      <a:pt x="156841" y="621096"/>
                    </a:cubicBezTo>
                    <a:cubicBezTo>
                      <a:pt x="124683" y="672828"/>
                      <a:pt x="31006" y="763709"/>
                      <a:pt x="31006" y="763709"/>
                    </a:cubicBezTo>
                    <a:lnTo>
                      <a:pt x="31006" y="763709"/>
                    </a:lnTo>
                    <a:cubicBezTo>
                      <a:pt x="26811" y="779089"/>
                      <a:pt x="-15134" y="853192"/>
                      <a:pt x="5839" y="855988"/>
                    </a:cubicBezTo>
                    <a:cubicBezTo>
                      <a:pt x="26811" y="858784"/>
                      <a:pt x="130276" y="805654"/>
                      <a:pt x="156841" y="780487"/>
                    </a:cubicBezTo>
                    <a:cubicBezTo>
                      <a:pt x="183406" y="755320"/>
                      <a:pt x="154045" y="739940"/>
                      <a:pt x="165230" y="704986"/>
                    </a:cubicBezTo>
                    <a:cubicBezTo>
                      <a:pt x="176415" y="670032"/>
                      <a:pt x="205777" y="622494"/>
                      <a:pt x="223953" y="570762"/>
                    </a:cubicBezTo>
                    <a:cubicBezTo>
                      <a:pt x="242129" y="519030"/>
                      <a:pt x="263102" y="444927"/>
                      <a:pt x="274287" y="394593"/>
                    </a:cubicBezTo>
                    <a:cubicBezTo>
                      <a:pt x="285472" y="344259"/>
                      <a:pt x="298056" y="313499"/>
                      <a:pt x="291065" y="268758"/>
                    </a:cubicBezTo>
                    <a:cubicBezTo>
                      <a:pt x="284074" y="224017"/>
                      <a:pt x="249120" y="169488"/>
                      <a:pt x="232342" y="126145"/>
                    </a:cubicBezTo>
                    <a:cubicBezTo>
                      <a:pt x="215564" y="82802"/>
                      <a:pt x="214166" y="28273"/>
                      <a:pt x="190397" y="8699"/>
                    </a:cubicBezTo>
                    <a:cubicBezTo>
                      <a:pt x="166628" y="-10875"/>
                      <a:pt x="89729" y="8699"/>
                      <a:pt x="89729" y="8699"/>
                    </a:cubicBezTo>
                    <a:lnTo>
                      <a:pt x="89729" y="8699"/>
                    </a:lnTo>
                  </a:path>
                </a:pathLst>
              </a:cu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Freeform 133">
                <a:extLst>
                  <a:ext uri="{FF2B5EF4-FFF2-40B4-BE49-F238E27FC236}">
                    <a16:creationId xmlns:a16="http://schemas.microsoft.com/office/drawing/2014/main" id="{AE5BC8B6-7D86-4C6D-BA9B-3B606CBEB1ED}"/>
                  </a:ext>
                </a:extLst>
              </p:cNvPr>
              <p:cNvSpPr/>
              <p:nvPr/>
            </p:nvSpPr>
            <p:spPr>
              <a:xfrm>
                <a:off x="7423440" y="1980403"/>
                <a:ext cx="120604" cy="565210"/>
              </a:xfrm>
              <a:custGeom>
                <a:avLst/>
                <a:gdLst>
                  <a:gd name="connsiteX0" fmla="*/ 94592 w 227293"/>
                  <a:gd name="connsiteY0" fmla="*/ 20169 h 835597"/>
                  <a:gd name="connsiteX1" fmla="*/ 44258 w 227293"/>
                  <a:gd name="connsiteY1" fmla="*/ 36947 h 835597"/>
                  <a:gd name="connsiteX2" fmla="*/ 161704 w 227293"/>
                  <a:gd name="connsiteY2" fmla="*/ 305395 h 835597"/>
                  <a:gd name="connsiteX3" fmla="*/ 2313 w 227293"/>
                  <a:gd name="connsiteY3" fmla="*/ 699678 h 835597"/>
                  <a:gd name="connsiteX4" fmla="*/ 69425 w 227293"/>
                  <a:gd name="connsiteY4" fmla="*/ 833902 h 835597"/>
                  <a:gd name="connsiteX5" fmla="*/ 102981 w 227293"/>
                  <a:gd name="connsiteY5" fmla="*/ 624177 h 835597"/>
                  <a:gd name="connsiteX6" fmla="*/ 203649 w 227293"/>
                  <a:gd name="connsiteY6" fmla="*/ 431230 h 835597"/>
                  <a:gd name="connsiteX7" fmla="*/ 220427 w 227293"/>
                  <a:gd name="connsiteY7" fmla="*/ 204727 h 835597"/>
                  <a:gd name="connsiteX8" fmla="*/ 94592 w 227293"/>
                  <a:gd name="connsiteY8" fmla="*/ 20169 h 835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27293" h="835597">
                    <a:moveTo>
                      <a:pt x="94592" y="20169"/>
                    </a:moveTo>
                    <a:cubicBezTo>
                      <a:pt x="65231" y="-7794"/>
                      <a:pt x="33073" y="-10591"/>
                      <a:pt x="44258" y="36947"/>
                    </a:cubicBezTo>
                    <a:cubicBezTo>
                      <a:pt x="55443" y="84485"/>
                      <a:pt x="168695" y="194940"/>
                      <a:pt x="161704" y="305395"/>
                    </a:cubicBezTo>
                    <a:cubicBezTo>
                      <a:pt x="154713" y="415850"/>
                      <a:pt x="17693" y="611594"/>
                      <a:pt x="2313" y="699678"/>
                    </a:cubicBezTo>
                    <a:cubicBezTo>
                      <a:pt x="-13067" y="787762"/>
                      <a:pt x="52647" y="846486"/>
                      <a:pt x="69425" y="833902"/>
                    </a:cubicBezTo>
                    <a:cubicBezTo>
                      <a:pt x="86203" y="821319"/>
                      <a:pt x="80610" y="691289"/>
                      <a:pt x="102981" y="624177"/>
                    </a:cubicBezTo>
                    <a:cubicBezTo>
                      <a:pt x="125352" y="557065"/>
                      <a:pt x="184075" y="501138"/>
                      <a:pt x="203649" y="431230"/>
                    </a:cubicBezTo>
                    <a:cubicBezTo>
                      <a:pt x="223223" y="361322"/>
                      <a:pt x="235807" y="267645"/>
                      <a:pt x="220427" y="204727"/>
                    </a:cubicBezTo>
                    <a:cubicBezTo>
                      <a:pt x="205047" y="141810"/>
                      <a:pt x="123953" y="48132"/>
                      <a:pt x="94592" y="20169"/>
                    </a:cubicBezTo>
                    <a:close/>
                  </a:path>
                </a:pathLst>
              </a:cu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Freeform 140">
                <a:extLst>
                  <a:ext uri="{FF2B5EF4-FFF2-40B4-BE49-F238E27FC236}">
                    <a16:creationId xmlns:a16="http://schemas.microsoft.com/office/drawing/2014/main" id="{A1CCF8D8-3EF2-460F-BE2C-BC0D0E663749}"/>
                  </a:ext>
                </a:extLst>
              </p:cNvPr>
              <p:cNvSpPr/>
              <p:nvPr/>
            </p:nvSpPr>
            <p:spPr>
              <a:xfrm>
                <a:off x="7510286" y="2004067"/>
                <a:ext cx="119264" cy="505281"/>
              </a:xfrm>
              <a:custGeom>
                <a:avLst/>
                <a:gdLst>
                  <a:gd name="connsiteX0" fmla="*/ 94592 w 227293"/>
                  <a:gd name="connsiteY0" fmla="*/ 20169 h 835597"/>
                  <a:gd name="connsiteX1" fmla="*/ 44258 w 227293"/>
                  <a:gd name="connsiteY1" fmla="*/ 36947 h 835597"/>
                  <a:gd name="connsiteX2" fmla="*/ 161704 w 227293"/>
                  <a:gd name="connsiteY2" fmla="*/ 305395 h 835597"/>
                  <a:gd name="connsiteX3" fmla="*/ 2313 w 227293"/>
                  <a:gd name="connsiteY3" fmla="*/ 699678 h 835597"/>
                  <a:gd name="connsiteX4" fmla="*/ 69425 w 227293"/>
                  <a:gd name="connsiteY4" fmla="*/ 833902 h 835597"/>
                  <a:gd name="connsiteX5" fmla="*/ 102981 w 227293"/>
                  <a:gd name="connsiteY5" fmla="*/ 624177 h 835597"/>
                  <a:gd name="connsiteX6" fmla="*/ 203649 w 227293"/>
                  <a:gd name="connsiteY6" fmla="*/ 431230 h 835597"/>
                  <a:gd name="connsiteX7" fmla="*/ 220427 w 227293"/>
                  <a:gd name="connsiteY7" fmla="*/ 204727 h 835597"/>
                  <a:gd name="connsiteX8" fmla="*/ 94592 w 227293"/>
                  <a:gd name="connsiteY8" fmla="*/ 20169 h 835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27293" h="835597">
                    <a:moveTo>
                      <a:pt x="94592" y="20169"/>
                    </a:moveTo>
                    <a:cubicBezTo>
                      <a:pt x="65231" y="-7794"/>
                      <a:pt x="33073" y="-10591"/>
                      <a:pt x="44258" y="36947"/>
                    </a:cubicBezTo>
                    <a:cubicBezTo>
                      <a:pt x="55443" y="84485"/>
                      <a:pt x="168695" y="194940"/>
                      <a:pt x="161704" y="305395"/>
                    </a:cubicBezTo>
                    <a:cubicBezTo>
                      <a:pt x="154713" y="415850"/>
                      <a:pt x="17693" y="611594"/>
                      <a:pt x="2313" y="699678"/>
                    </a:cubicBezTo>
                    <a:cubicBezTo>
                      <a:pt x="-13067" y="787762"/>
                      <a:pt x="52647" y="846486"/>
                      <a:pt x="69425" y="833902"/>
                    </a:cubicBezTo>
                    <a:cubicBezTo>
                      <a:pt x="86203" y="821319"/>
                      <a:pt x="80610" y="691289"/>
                      <a:pt x="102981" y="624177"/>
                    </a:cubicBezTo>
                    <a:cubicBezTo>
                      <a:pt x="125352" y="557065"/>
                      <a:pt x="184075" y="501138"/>
                      <a:pt x="203649" y="431230"/>
                    </a:cubicBezTo>
                    <a:cubicBezTo>
                      <a:pt x="223223" y="361322"/>
                      <a:pt x="235807" y="267645"/>
                      <a:pt x="220427" y="204727"/>
                    </a:cubicBezTo>
                    <a:cubicBezTo>
                      <a:pt x="205047" y="141810"/>
                      <a:pt x="123953" y="48132"/>
                      <a:pt x="94592" y="20169"/>
                    </a:cubicBezTo>
                    <a:close/>
                  </a:path>
                </a:pathLst>
              </a:cu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Freeform 142">
                <a:extLst>
                  <a:ext uri="{FF2B5EF4-FFF2-40B4-BE49-F238E27FC236}">
                    <a16:creationId xmlns:a16="http://schemas.microsoft.com/office/drawing/2014/main" id="{BE2C6568-F2E5-4005-835C-230C5C5EC566}"/>
                  </a:ext>
                </a:extLst>
              </p:cNvPr>
              <p:cNvSpPr/>
              <p:nvPr/>
            </p:nvSpPr>
            <p:spPr>
              <a:xfrm>
                <a:off x="7642802" y="2043778"/>
                <a:ext cx="82936" cy="342632"/>
              </a:xfrm>
              <a:custGeom>
                <a:avLst/>
                <a:gdLst>
                  <a:gd name="connsiteX0" fmla="*/ 94592 w 227293"/>
                  <a:gd name="connsiteY0" fmla="*/ 20169 h 835597"/>
                  <a:gd name="connsiteX1" fmla="*/ 44258 w 227293"/>
                  <a:gd name="connsiteY1" fmla="*/ 36947 h 835597"/>
                  <a:gd name="connsiteX2" fmla="*/ 161704 w 227293"/>
                  <a:gd name="connsiteY2" fmla="*/ 305395 h 835597"/>
                  <a:gd name="connsiteX3" fmla="*/ 2313 w 227293"/>
                  <a:gd name="connsiteY3" fmla="*/ 699678 h 835597"/>
                  <a:gd name="connsiteX4" fmla="*/ 69425 w 227293"/>
                  <a:gd name="connsiteY4" fmla="*/ 833902 h 835597"/>
                  <a:gd name="connsiteX5" fmla="*/ 102981 w 227293"/>
                  <a:gd name="connsiteY5" fmla="*/ 624177 h 835597"/>
                  <a:gd name="connsiteX6" fmla="*/ 203649 w 227293"/>
                  <a:gd name="connsiteY6" fmla="*/ 431230 h 835597"/>
                  <a:gd name="connsiteX7" fmla="*/ 220427 w 227293"/>
                  <a:gd name="connsiteY7" fmla="*/ 204727 h 835597"/>
                  <a:gd name="connsiteX8" fmla="*/ 94592 w 227293"/>
                  <a:gd name="connsiteY8" fmla="*/ 20169 h 835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27293" h="835597">
                    <a:moveTo>
                      <a:pt x="94592" y="20169"/>
                    </a:moveTo>
                    <a:cubicBezTo>
                      <a:pt x="65231" y="-7794"/>
                      <a:pt x="33073" y="-10591"/>
                      <a:pt x="44258" y="36947"/>
                    </a:cubicBezTo>
                    <a:cubicBezTo>
                      <a:pt x="55443" y="84485"/>
                      <a:pt x="168695" y="194940"/>
                      <a:pt x="161704" y="305395"/>
                    </a:cubicBezTo>
                    <a:cubicBezTo>
                      <a:pt x="154713" y="415850"/>
                      <a:pt x="17693" y="611594"/>
                      <a:pt x="2313" y="699678"/>
                    </a:cubicBezTo>
                    <a:cubicBezTo>
                      <a:pt x="-13067" y="787762"/>
                      <a:pt x="52647" y="846486"/>
                      <a:pt x="69425" y="833902"/>
                    </a:cubicBezTo>
                    <a:cubicBezTo>
                      <a:pt x="86203" y="821319"/>
                      <a:pt x="80610" y="691289"/>
                      <a:pt x="102981" y="624177"/>
                    </a:cubicBezTo>
                    <a:cubicBezTo>
                      <a:pt x="125352" y="557065"/>
                      <a:pt x="184075" y="501138"/>
                      <a:pt x="203649" y="431230"/>
                    </a:cubicBezTo>
                    <a:cubicBezTo>
                      <a:pt x="223223" y="361322"/>
                      <a:pt x="235807" y="267645"/>
                      <a:pt x="220427" y="204727"/>
                    </a:cubicBezTo>
                    <a:cubicBezTo>
                      <a:pt x="205047" y="141810"/>
                      <a:pt x="123953" y="48132"/>
                      <a:pt x="94592" y="20169"/>
                    </a:cubicBezTo>
                    <a:close/>
                  </a:path>
                </a:pathLst>
              </a:cu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id="{C8681651-4E0C-4D81-A45C-A567D3C7B9E6}"/>
                  </a:ext>
                </a:extLst>
              </p:cNvPr>
              <p:cNvSpPr/>
              <p:nvPr/>
            </p:nvSpPr>
            <p:spPr>
              <a:xfrm>
                <a:off x="7779043" y="2305558"/>
                <a:ext cx="53096" cy="80852"/>
              </a:xfrm>
              <a:prstGeom prst="ellipse">
                <a:avLst/>
              </a:pr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5BECAADF-AABA-47CD-B761-6BACC70AF7B3}"/>
                  </a:ext>
                </a:extLst>
              </p:cNvPr>
              <p:cNvSpPr/>
              <p:nvPr/>
            </p:nvSpPr>
            <p:spPr>
              <a:xfrm>
                <a:off x="7715288" y="1958187"/>
                <a:ext cx="53096" cy="80852"/>
              </a:xfrm>
              <a:prstGeom prst="ellipse">
                <a:avLst/>
              </a:pr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id="{CCB7EA56-9A54-4414-B41E-A1695FB5AECB}"/>
                  </a:ext>
                </a:extLst>
              </p:cNvPr>
              <p:cNvSpPr/>
              <p:nvPr/>
            </p:nvSpPr>
            <p:spPr>
              <a:xfrm>
                <a:off x="7885447" y="2039039"/>
                <a:ext cx="53096" cy="80852"/>
              </a:xfrm>
              <a:prstGeom prst="ellipse">
                <a:avLst/>
              </a:prstGeom>
              <a:solidFill>
                <a:srgbClr val="FF0000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1C71B3AD-271C-4BE4-B4C3-7EB4E660BEBF}"/>
                  </a:ext>
                </a:extLst>
              </p:cNvPr>
              <p:cNvGrpSpPr/>
              <p:nvPr/>
            </p:nvGrpSpPr>
            <p:grpSpPr>
              <a:xfrm>
                <a:off x="7343660" y="1928107"/>
                <a:ext cx="96248" cy="80852"/>
                <a:chOff x="7901591" y="1844412"/>
                <a:chExt cx="136860" cy="119530"/>
              </a:xfrm>
              <a:solidFill>
                <a:schemeClr val="bg2">
                  <a:lumMod val="25000"/>
                </a:schemeClr>
              </a:solidFill>
            </p:grpSpPr>
            <p:sp>
              <p:nvSpPr>
                <p:cNvPr id="34" name="Oval 33">
                  <a:extLst>
                    <a:ext uri="{FF2B5EF4-FFF2-40B4-BE49-F238E27FC236}">
                      <a16:creationId xmlns:a16="http://schemas.microsoft.com/office/drawing/2014/main" id="{C32A85C8-E6D7-48B1-B4D5-303632DEDEA2}"/>
                    </a:ext>
                  </a:extLst>
                </p:cNvPr>
                <p:cNvSpPr/>
                <p:nvPr/>
              </p:nvSpPr>
              <p:spPr>
                <a:xfrm>
                  <a:off x="7901591" y="1844412"/>
                  <a:ext cx="75501" cy="119530"/>
                </a:xfrm>
                <a:prstGeom prst="ellipse">
                  <a:avLst/>
                </a:prstGeom>
                <a:grp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C873763B-D608-48C7-8A44-29E6A7CFED3E}"/>
                    </a:ext>
                  </a:extLst>
                </p:cNvPr>
                <p:cNvSpPr/>
                <p:nvPr/>
              </p:nvSpPr>
              <p:spPr>
                <a:xfrm>
                  <a:off x="7944812" y="1854075"/>
                  <a:ext cx="93639" cy="75946"/>
                </a:xfrm>
                <a:prstGeom prst="ellipse">
                  <a:avLst/>
                </a:prstGeom>
                <a:grp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49AE49D1-616D-4DD6-B8ED-7026181A3B34}"/>
                  </a:ext>
                </a:extLst>
              </p:cNvPr>
              <p:cNvGrpSpPr/>
              <p:nvPr/>
            </p:nvGrpSpPr>
            <p:grpSpPr>
              <a:xfrm>
                <a:off x="7286769" y="2493179"/>
                <a:ext cx="108132" cy="80852"/>
                <a:chOff x="8053991" y="1996812"/>
                <a:chExt cx="153760" cy="119530"/>
              </a:xfrm>
              <a:solidFill>
                <a:schemeClr val="bg2">
                  <a:lumMod val="25000"/>
                </a:schemeClr>
              </a:solidFill>
            </p:grpSpPr>
            <p:sp>
              <p:nvSpPr>
                <p:cNvPr id="32" name="Oval 31">
                  <a:extLst>
                    <a:ext uri="{FF2B5EF4-FFF2-40B4-BE49-F238E27FC236}">
                      <a16:creationId xmlns:a16="http://schemas.microsoft.com/office/drawing/2014/main" id="{AB3A5016-BE11-453B-92A9-5AE75C5E313E}"/>
                    </a:ext>
                  </a:extLst>
                </p:cNvPr>
                <p:cNvSpPr/>
                <p:nvPr/>
              </p:nvSpPr>
              <p:spPr>
                <a:xfrm>
                  <a:off x="8053991" y="1996812"/>
                  <a:ext cx="75501" cy="119530"/>
                </a:xfrm>
                <a:prstGeom prst="ellipse">
                  <a:avLst/>
                </a:prstGeom>
                <a:grp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Oval 32">
                  <a:extLst>
                    <a:ext uri="{FF2B5EF4-FFF2-40B4-BE49-F238E27FC236}">
                      <a16:creationId xmlns:a16="http://schemas.microsoft.com/office/drawing/2014/main" id="{E616B64D-5380-4A5B-8DA6-A2C1F1F9AB25}"/>
                    </a:ext>
                  </a:extLst>
                </p:cNvPr>
                <p:cNvSpPr/>
                <p:nvPr/>
              </p:nvSpPr>
              <p:spPr>
                <a:xfrm>
                  <a:off x="8114112" y="2014988"/>
                  <a:ext cx="93639" cy="75946"/>
                </a:xfrm>
                <a:prstGeom prst="ellipse">
                  <a:avLst/>
                </a:prstGeom>
                <a:grp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6223FD0B-63DB-41D0-BE76-FD14C74A1F4F}"/>
                  </a:ext>
                </a:extLst>
              </p:cNvPr>
              <p:cNvGrpSpPr/>
              <p:nvPr/>
            </p:nvGrpSpPr>
            <p:grpSpPr>
              <a:xfrm>
                <a:off x="7414523" y="2240220"/>
                <a:ext cx="96248" cy="80852"/>
                <a:chOff x="7901591" y="1844412"/>
                <a:chExt cx="136860" cy="119530"/>
              </a:xfrm>
              <a:solidFill>
                <a:schemeClr val="bg2">
                  <a:lumMod val="25000"/>
                </a:schemeClr>
              </a:solidFill>
            </p:grpSpPr>
            <p:sp>
              <p:nvSpPr>
                <p:cNvPr id="30" name="Oval 29">
                  <a:extLst>
                    <a:ext uri="{FF2B5EF4-FFF2-40B4-BE49-F238E27FC236}">
                      <a16:creationId xmlns:a16="http://schemas.microsoft.com/office/drawing/2014/main" id="{F8FF2633-C473-4BB5-9AA5-5F6D56719A36}"/>
                    </a:ext>
                  </a:extLst>
                </p:cNvPr>
                <p:cNvSpPr/>
                <p:nvPr/>
              </p:nvSpPr>
              <p:spPr>
                <a:xfrm>
                  <a:off x="7901591" y="1844412"/>
                  <a:ext cx="75501" cy="119530"/>
                </a:xfrm>
                <a:prstGeom prst="ellipse">
                  <a:avLst/>
                </a:prstGeom>
                <a:grp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" name="Oval 30">
                  <a:extLst>
                    <a:ext uri="{FF2B5EF4-FFF2-40B4-BE49-F238E27FC236}">
                      <a16:creationId xmlns:a16="http://schemas.microsoft.com/office/drawing/2014/main" id="{882F8B17-ACA1-43AF-81FD-71B9AAF86C8B}"/>
                    </a:ext>
                  </a:extLst>
                </p:cNvPr>
                <p:cNvSpPr/>
                <p:nvPr/>
              </p:nvSpPr>
              <p:spPr>
                <a:xfrm>
                  <a:off x="7944812" y="1854075"/>
                  <a:ext cx="93639" cy="75946"/>
                </a:xfrm>
                <a:prstGeom prst="ellipse">
                  <a:avLst/>
                </a:prstGeom>
                <a:grp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BD0731A-103F-4704-8AAD-48AC5B7E2237}"/>
                  </a:ext>
                </a:extLst>
              </p:cNvPr>
              <p:cNvSpPr txBox="1"/>
              <p:nvPr/>
            </p:nvSpPr>
            <p:spPr>
              <a:xfrm>
                <a:off x="7117297" y="1707145"/>
                <a:ext cx="522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RER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EC08EBA-1A6A-4F8B-8DA6-77DFC6458A66}"/>
                  </a:ext>
                </a:extLst>
              </p:cNvPr>
              <p:cNvSpPr txBox="1"/>
              <p:nvPr/>
            </p:nvSpPr>
            <p:spPr>
              <a:xfrm>
                <a:off x="7291505" y="2511834"/>
                <a:ext cx="522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Golgi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A55A668-C2C8-40A5-AF80-FEAE9B7B1D2E}"/>
                  </a:ext>
                </a:extLst>
              </p:cNvPr>
              <p:cNvSpPr txBox="1"/>
              <p:nvPr/>
            </p:nvSpPr>
            <p:spPr>
              <a:xfrm>
                <a:off x="7733363" y="1687873"/>
                <a:ext cx="7471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vesicle</a:t>
                </a:r>
              </a:p>
            </p:txBody>
          </p:sp>
          <p:sp>
            <p:nvSpPr>
              <p:cNvPr id="20" name="Oval 19">
                <a:extLst>
                  <a:ext uri="{FF2B5EF4-FFF2-40B4-BE49-F238E27FC236}">
                    <a16:creationId xmlns:a16="http://schemas.microsoft.com/office/drawing/2014/main" id="{9591C8ED-E344-4CEA-BE94-9478036DB1D1}"/>
                  </a:ext>
                </a:extLst>
              </p:cNvPr>
              <p:cNvSpPr/>
              <p:nvPr/>
            </p:nvSpPr>
            <p:spPr>
              <a:xfrm>
                <a:off x="8209789" y="2066361"/>
                <a:ext cx="47197" cy="4759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Oval 20">
                <a:extLst>
                  <a:ext uri="{FF2B5EF4-FFF2-40B4-BE49-F238E27FC236}">
                    <a16:creationId xmlns:a16="http://schemas.microsoft.com/office/drawing/2014/main" id="{31C0FC2B-5BE4-46D2-A96D-D51533DD697D}"/>
                  </a:ext>
                </a:extLst>
              </p:cNvPr>
              <p:cNvSpPr/>
              <p:nvPr/>
            </p:nvSpPr>
            <p:spPr>
              <a:xfrm>
                <a:off x="8063649" y="2019980"/>
                <a:ext cx="47197" cy="4759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Oval 21">
                <a:extLst>
                  <a:ext uri="{FF2B5EF4-FFF2-40B4-BE49-F238E27FC236}">
                    <a16:creationId xmlns:a16="http://schemas.microsoft.com/office/drawing/2014/main" id="{D954693A-E46D-47C4-866C-CF3496226748}"/>
                  </a:ext>
                </a:extLst>
              </p:cNvPr>
              <p:cNvSpPr/>
              <p:nvPr/>
            </p:nvSpPr>
            <p:spPr>
              <a:xfrm>
                <a:off x="8085525" y="2131054"/>
                <a:ext cx="47197" cy="4759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Oval 22">
                <a:extLst>
                  <a:ext uri="{FF2B5EF4-FFF2-40B4-BE49-F238E27FC236}">
                    <a16:creationId xmlns:a16="http://schemas.microsoft.com/office/drawing/2014/main" id="{8FF9BAB2-E843-43A6-AF15-FC2F96C8F690}"/>
                  </a:ext>
                </a:extLst>
              </p:cNvPr>
              <p:cNvSpPr/>
              <p:nvPr/>
            </p:nvSpPr>
            <p:spPr>
              <a:xfrm>
                <a:off x="8233387" y="2185753"/>
                <a:ext cx="47197" cy="4759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Oval 23">
                <a:extLst>
                  <a:ext uri="{FF2B5EF4-FFF2-40B4-BE49-F238E27FC236}">
                    <a16:creationId xmlns:a16="http://schemas.microsoft.com/office/drawing/2014/main" id="{B8B94FEB-9FBB-473B-87EE-F4A1B5B80BDD}"/>
                  </a:ext>
                </a:extLst>
              </p:cNvPr>
              <p:cNvSpPr/>
              <p:nvPr/>
            </p:nvSpPr>
            <p:spPr>
              <a:xfrm>
                <a:off x="8342858" y="2130284"/>
                <a:ext cx="47197" cy="4759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F1A1FFD-3104-4AC6-8052-381D3B8DAA20}"/>
                  </a:ext>
                </a:extLst>
              </p:cNvPr>
              <p:cNvSpPr txBox="1"/>
              <p:nvPr/>
            </p:nvSpPr>
            <p:spPr>
              <a:xfrm>
                <a:off x="8249100" y="2332235"/>
                <a:ext cx="15889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ER-Golgi-secretion</a:t>
                </a:r>
              </a:p>
            </p:txBody>
          </p:sp>
          <p:sp>
            <p:nvSpPr>
              <p:cNvPr id="26" name="Freeform 175">
                <a:extLst>
                  <a:ext uri="{FF2B5EF4-FFF2-40B4-BE49-F238E27FC236}">
                    <a16:creationId xmlns:a16="http://schemas.microsoft.com/office/drawing/2014/main" id="{75E8A8C5-AB74-4DAA-99D6-16A910C06D8B}"/>
                  </a:ext>
                </a:extLst>
              </p:cNvPr>
              <p:cNvSpPr/>
              <p:nvPr/>
            </p:nvSpPr>
            <p:spPr>
              <a:xfrm>
                <a:off x="7521032" y="2131384"/>
                <a:ext cx="554565" cy="74398"/>
              </a:xfrm>
              <a:custGeom>
                <a:avLst/>
                <a:gdLst>
                  <a:gd name="connsiteX0" fmla="*/ 0 w 788565"/>
                  <a:gd name="connsiteY0" fmla="*/ 109057 h 109988"/>
                  <a:gd name="connsiteX1" fmla="*/ 268448 w 788565"/>
                  <a:gd name="connsiteY1" fmla="*/ 100668 h 109988"/>
                  <a:gd name="connsiteX2" fmla="*/ 385894 w 788565"/>
                  <a:gd name="connsiteY2" fmla="*/ 41945 h 109988"/>
                  <a:gd name="connsiteX3" fmla="*/ 578840 w 788565"/>
                  <a:gd name="connsiteY3" fmla="*/ 8389 h 109988"/>
                  <a:gd name="connsiteX4" fmla="*/ 788565 w 788565"/>
                  <a:gd name="connsiteY4" fmla="*/ 0 h 1099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88565" h="109988">
                    <a:moveTo>
                      <a:pt x="0" y="109057"/>
                    </a:moveTo>
                    <a:cubicBezTo>
                      <a:pt x="102066" y="110455"/>
                      <a:pt x="204132" y="111853"/>
                      <a:pt x="268448" y="100668"/>
                    </a:cubicBezTo>
                    <a:cubicBezTo>
                      <a:pt x="332764" y="89483"/>
                      <a:pt x="334162" y="57325"/>
                      <a:pt x="385894" y="41945"/>
                    </a:cubicBezTo>
                    <a:cubicBezTo>
                      <a:pt x="437626" y="26565"/>
                      <a:pt x="511728" y="15380"/>
                      <a:pt x="578840" y="8389"/>
                    </a:cubicBezTo>
                    <a:cubicBezTo>
                      <a:pt x="645952" y="1398"/>
                      <a:pt x="717258" y="699"/>
                      <a:pt x="788565" y="0"/>
                    </a:cubicBezTo>
                  </a:path>
                </a:pathLst>
              </a:custGeom>
              <a:noFill/>
              <a:ln>
                <a:prstDash val="sysDash"/>
                <a:tailEnd type="stealt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2C22EA7D-07D9-4421-AA84-8BB13F453D6B}"/>
                  </a:ext>
                </a:extLst>
              </p:cNvPr>
              <p:cNvCxnSpPr>
                <a:endCxn id="34" idx="3"/>
              </p:cNvCxnSpPr>
              <p:nvPr/>
            </p:nvCxnSpPr>
            <p:spPr>
              <a:xfrm>
                <a:off x="7259668" y="1870667"/>
                <a:ext cx="91767" cy="12645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>
                <a:extLst>
                  <a:ext uri="{FF2B5EF4-FFF2-40B4-BE49-F238E27FC236}">
                    <a16:creationId xmlns:a16="http://schemas.microsoft.com/office/drawing/2014/main" id="{A31750D9-7342-4D11-A20A-03F788C7EC59}"/>
                  </a:ext>
                </a:extLst>
              </p:cNvPr>
              <p:cNvCxnSpPr/>
              <p:nvPr/>
            </p:nvCxnSpPr>
            <p:spPr>
              <a:xfrm flipH="1">
                <a:off x="7773783" y="1857428"/>
                <a:ext cx="103325" cy="11196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C0BD7D3D-856E-4AC5-A0A8-049E820A55C7}"/>
                  </a:ext>
                </a:extLst>
              </p:cNvPr>
              <p:cNvCxnSpPr/>
              <p:nvPr/>
            </p:nvCxnSpPr>
            <p:spPr>
              <a:xfrm flipH="1" flipV="1">
                <a:off x="7578649" y="2444147"/>
                <a:ext cx="42899" cy="17066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4DA4B83-132B-49D9-8990-147A391A579D}"/>
                </a:ext>
              </a:extLst>
            </p:cNvPr>
            <p:cNvSpPr txBox="1"/>
            <p:nvPr/>
          </p:nvSpPr>
          <p:spPr>
            <a:xfrm>
              <a:off x="7410022" y="3111857"/>
              <a:ext cx="519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chemeClr val="bg1"/>
                  </a:solidFill>
                </a:rPr>
                <a:t>Nu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3E427DDA-DB8B-4051-BB81-07294C133A0E}"/>
                </a:ext>
              </a:extLst>
            </p:cNvPr>
            <p:cNvCxnSpPr/>
            <p:nvPr/>
          </p:nvCxnSpPr>
          <p:spPr>
            <a:xfrm flipH="1" flipV="1">
              <a:off x="8757675" y="3263544"/>
              <a:ext cx="15986" cy="1530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DDB2426B-4F98-464C-83C9-0FBF621262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38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88651" y="2798652"/>
              <a:ext cx="2229079" cy="1050103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8435D6B-553C-4DEB-8E0A-ACDD110A7BC7}"/>
                </a:ext>
              </a:extLst>
            </p:cNvPr>
            <p:cNvSpPr txBox="1"/>
            <p:nvPr/>
          </p:nvSpPr>
          <p:spPr>
            <a:xfrm>
              <a:off x="5147143" y="3590462"/>
              <a:ext cx="1002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SP-</a:t>
              </a:r>
              <a:r>
                <a:rPr lang="en-US" sz="1200" b="1" dirty="0" err="1">
                  <a:solidFill>
                    <a:schemeClr val="bg1"/>
                  </a:solidFill>
                </a:rPr>
                <a:t>gLuc</a:t>
              </a:r>
              <a:r>
                <a:rPr lang="en-US" sz="1200" b="1" dirty="0">
                  <a:solidFill>
                    <a:schemeClr val="bg1"/>
                  </a:solidFill>
                </a:rPr>
                <a:t>-RFP</a:t>
              </a: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8AFC3B2A-BA69-4B2D-B56A-875779234855}"/>
                </a:ext>
              </a:extLst>
            </p:cNvPr>
            <p:cNvCxnSpPr/>
            <p:nvPr/>
          </p:nvCxnSpPr>
          <p:spPr>
            <a:xfrm>
              <a:off x="5459326" y="3086256"/>
              <a:ext cx="93503" cy="221423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F491BE3-8208-484C-9622-AF1AA2E63621}"/>
                </a:ext>
              </a:extLst>
            </p:cNvPr>
            <p:cNvSpPr txBox="1"/>
            <p:nvPr/>
          </p:nvSpPr>
          <p:spPr>
            <a:xfrm>
              <a:off x="5281560" y="2867973"/>
              <a:ext cx="4687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ER</a:t>
              </a: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5CA33186-A7EA-4B36-80C2-428BCFFCD3BA}"/>
                </a:ext>
              </a:extLst>
            </p:cNvPr>
            <p:cNvCxnSpPr/>
            <p:nvPr/>
          </p:nvCxnSpPr>
          <p:spPr>
            <a:xfrm>
              <a:off x="6889071" y="2873979"/>
              <a:ext cx="348105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8AA7D850-B841-4B10-930A-626238C3EE0C}"/>
                </a:ext>
              </a:extLst>
            </p:cNvPr>
            <p:cNvCxnSpPr/>
            <p:nvPr/>
          </p:nvCxnSpPr>
          <p:spPr>
            <a:xfrm>
              <a:off x="5753047" y="2856440"/>
              <a:ext cx="348105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0598F81B-D362-4D8D-84FE-B8B9EE9EBC66}"/>
                </a:ext>
              </a:extLst>
            </p:cNvPr>
            <p:cNvGrpSpPr/>
            <p:nvPr/>
          </p:nvGrpSpPr>
          <p:grpSpPr>
            <a:xfrm>
              <a:off x="7313029" y="3973342"/>
              <a:ext cx="3169914" cy="973495"/>
              <a:chOff x="6890344" y="2859979"/>
              <a:chExt cx="3169914" cy="973495"/>
            </a:xfrm>
          </p:grpSpPr>
          <p:sp>
            <p:nvSpPr>
              <p:cNvPr id="45" name="Oval 44">
                <a:extLst>
                  <a:ext uri="{FF2B5EF4-FFF2-40B4-BE49-F238E27FC236}">
                    <a16:creationId xmlns:a16="http://schemas.microsoft.com/office/drawing/2014/main" id="{FDA39CBF-D7B7-45D6-B9C1-25C867DA59FD}"/>
                  </a:ext>
                </a:extLst>
              </p:cNvPr>
              <p:cNvSpPr/>
              <p:nvPr/>
            </p:nvSpPr>
            <p:spPr>
              <a:xfrm>
                <a:off x="6890344" y="2859979"/>
                <a:ext cx="1164967" cy="969278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Oval 45">
                <a:extLst>
                  <a:ext uri="{FF2B5EF4-FFF2-40B4-BE49-F238E27FC236}">
                    <a16:creationId xmlns:a16="http://schemas.microsoft.com/office/drawing/2014/main" id="{BB4155B8-64DB-45CF-86F5-F44201ECDBC8}"/>
                  </a:ext>
                </a:extLst>
              </p:cNvPr>
              <p:cNvSpPr/>
              <p:nvPr/>
            </p:nvSpPr>
            <p:spPr>
              <a:xfrm>
                <a:off x="6949936" y="3058112"/>
                <a:ext cx="466070" cy="541300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i="1" dirty="0"/>
              </a:p>
            </p:txBody>
          </p:sp>
          <p:sp>
            <p:nvSpPr>
              <p:cNvPr id="47" name="Freeform 182">
                <a:extLst>
                  <a:ext uri="{FF2B5EF4-FFF2-40B4-BE49-F238E27FC236}">
                    <a16:creationId xmlns:a16="http://schemas.microsoft.com/office/drawing/2014/main" id="{21DDED50-2231-4A92-B17A-76ADE497B447}"/>
                  </a:ext>
                </a:extLst>
              </p:cNvPr>
              <p:cNvSpPr/>
              <p:nvPr/>
            </p:nvSpPr>
            <p:spPr>
              <a:xfrm>
                <a:off x="7477047" y="2868481"/>
                <a:ext cx="222038" cy="130834"/>
              </a:xfrm>
              <a:custGeom>
                <a:avLst/>
                <a:gdLst>
                  <a:gd name="connsiteX0" fmla="*/ 5335 w 315728"/>
                  <a:gd name="connsiteY0" fmla="*/ 0 h 276577"/>
                  <a:gd name="connsiteX1" fmla="*/ 164726 w 315728"/>
                  <a:gd name="connsiteY1" fmla="*/ 25167 h 276577"/>
                  <a:gd name="connsiteX2" fmla="*/ 22113 w 315728"/>
                  <a:gd name="connsiteY2" fmla="*/ 100668 h 276577"/>
                  <a:gd name="connsiteX3" fmla="*/ 30502 w 315728"/>
                  <a:gd name="connsiteY3" fmla="*/ 234892 h 276577"/>
                  <a:gd name="connsiteX4" fmla="*/ 307339 w 315728"/>
                  <a:gd name="connsiteY4" fmla="*/ 268448 h 276577"/>
                  <a:gd name="connsiteX5" fmla="*/ 181504 w 315728"/>
                  <a:gd name="connsiteY5" fmla="*/ 100668 h 276577"/>
                  <a:gd name="connsiteX6" fmla="*/ 248616 w 315728"/>
                  <a:gd name="connsiteY6" fmla="*/ 67112 h 276577"/>
                  <a:gd name="connsiteX7" fmla="*/ 315728 w 315728"/>
                  <a:gd name="connsiteY7" fmla="*/ 100668 h 2765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315728" h="276577">
                    <a:moveTo>
                      <a:pt x="5335" y="0"/>
                    </a:moveTo>
                    <a:cubicBezTo>
                      <a:pt x="83632" y="4194"/>
                      <a:pt x="161930" y="8389"/>
                      <a:pt x="164726" y="25167"/>
                    </a:cubicBezTo>
                    <a:cubicBezTo>
                      <a:pt x="167522" y="41945"/>
                      <a:pt x="44484" y="65714"/>
                      <a:pt x="22113" y="100668"/>
                    </a:cubicBezTo>
                    <a:cubicBezTo>
                      <a:pt x="-258" y="135622"/>
                      <a:pt x="-17035" y="206929"/>
                      <a:pt x="30502" y="234892"/>
                    </a:cubicBezTo>
                    <a:cubicBezTo>
                      <a:pt x="78039" y="262855"/>
                      <a:pt x="282172" y="290819"/>
                      <a:pt x="307339" y="268448"/>
                    </a:cubicBezTo>
                    <a:cubicBezTo>
                      <a:pt x="332506" y="246077"/>
                      <a:pt x="191291" y="134224"/>
                      <a:pt x="181504" y="100668"/>
                    </a:cubicBezTo>
                    <a:cubicBezTo>
                      <a:pt x="171717" y="67112"/>
                      <a:pt x="226245" y="67112"/>
                      <a:pt x="248616" y="67112"/>
                    </a:cubicBezTo>
                    <a:cubicBezTo>
                      <a:pt x="270987" y="67112"/>
                      <a:pt x="293357" y="83890"/>
                      <a:pt x="315728" y="100668"/>
                    </a:cubicBezTo>
                  </a:path>
                </a:pathLst>
              </a:cu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Freeform 183">
                <a:extLst>
                  <a:ext uri="{FF2B5EF4-FFF2-40B4-BE49-F238E27FC236}">
                    <a16:creationId xmlns:a16="http://schemas.microsoft.com/office/drawing/2014/main" id="{928ED015-F505-4ED1-81A6-4DFB17EC7571}"/>
                  </a:ext>
                </a:extLst>
              </p:cNvPr>
              <p:cNvSpPr/>
              <p:nvPr/>
            </p:nvSpPr>
            <p:spPr>
              <a:xfrm>
                <a:off x="7472826" y="3064377"/>
                <a:ext cx="317410" cy="182353"/>
              </a:xfrm>
              <a:custGeom>
                <a:avLst/>
                <a:gdLst>
                  <a:gd name="connsiteX0" fmla="*/ 323762 w 491921"/>
                  <a:gd name="connsiteY0" fmla="*/ 165297 h 450762"/>
                  <a:gd name="connsiteX1" fmla="*/ 231483 w 491921"/>
                  <a:gd name="connsiteY1" fmla="*/ 47851 h 450762"/>
                  <a:gd name="connsiteX2" fmla="*/ 55314 w 491921"/>
                  <a:gd name="connsiteY2" fmla="*/ 14295 h 450762"/>
                  <a:gd name="connsiteX3" fmla="*/ 13369 w 491921"/>
                  <a:gd name="connsiteY3" fmla="*/ 274354 h 450762"/>
                  <a:gd name="connsiteX4" fmla="*/ 265039 w 491921"/>
                  <a:gd name="connsiteY4" fmla="*/ 450523 h 450762"/>
                  <a:gd name="connsiteX5" fmla="*/ 491541 w 491921"/>
                  <a:gd name="connsiteY5" fmla="*/ 307910 h 450762"/>
                  <a:gd name="connsiteX6" fmla="*/ 323762 w 491921"/>
                  <a:gd name="connsiteY6" fmla="*/ 165297 h 4507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491921" h="450762">
                    <a:moveTo>
                      <a:pt x="323762" y="165297"/>
                    </a:moveTo>
                    <a:cubicBezTo>
                      <a:pt x="280419" y="121954"/>
                      <a:pt x="276224" y="73018"/>
                      <a:pt x="231483" y="47851"/>
                    </a:cubicBezTo>
                    <a:cubicBezTo>
                      <a:pt x="186742" y="22684"/>
                      <a:pt x="91666" y="-23456"/>
                      <a:pt x="55314" y="14295"/>
                    </a:cubicBezTo>
                    <a:cubicBezTo>
                      <a:pt x="18962" y="52046"/>
                      <a:pt x="-21585" y="201649"/>
                      <a:pt x="13369" y="274354"/>
                    </a:cubicBezTo>
                    <a:cubicBezTo>
                      <a:pt x="48323" y="347059"/>
                      <a:pt x="185344" y="444930"/>
                      <a:pt x="265039" y="450523"/>
                    </a:cubicBezTo>
                    <a:cubicBezTo>
                      <a:pt x="344734" y="456116"/>
                      <a:pt x="483152" y="362438"/>
                      <a:pt x="491541" y="307910"/>
                    </a:cubicBezTo>
                    <a:cubicBezTo>
                      <a:pt x="499930" y="253382"/>
                      <a:pt x="367105" y="208640"/>
                      <a:pt x="323762" y="165297"/>
                    </a:cubicBezTo>
                    <a:close/>
                  </a:path>
                </a:pathLst>
              </a:cu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Freeform 184">
                <a:extLst>
                  <a:ext uri="{FF2B5EF4-FFF2-40B4-BE49-F238E27FC236}">
                    <a16:creationId xmlns:a16="http://schemas.microsoft.com/office/drawing/2014/main" id="{0730B9C3-EF39-49E4-86F1-0DB265F92894}"/>
                  </a:ext>
                </a:extLst>
              </p:cNvPr>
              <p:cNvSpPr/>
              <p:nvPr/>
            </p:nvSpPr>
            <p:spPr>
              <a:xfrm>
                <a:off x="7429716" y="3330984"/>
                <a:ext cx="327862" cy="267680"/>
              </a:xfrm>
              <a:custGeom>
                <a:avLst/>
                <a:gdLst>
                  <a:gd name="connsiteX0" fmla="*/ 323762 w 491921"/>
                  <a:gd name="connsiteY0" fmla="*/ 165297 h 450762"/>
                  <a:gd name="connsiteX1" fmla="*/ 231483 w 491921"/>
                  <a:gd name="connsiteY1" fmla="*/ 47851 h 450762"/>
                  <a:gd name="connsiteX2" fmla="*/ 55314 w 491921"/>
                  <a:gd name="connsiteY2" fmla="*/ 14295 h 450762"/>
                  <a:gd name="connsiteX3" fmla="*/ 13369 w 491921"/>
                  <a:gd name="connsiteY3" fmla="*/ 274354 h 450762"/>
                  <a:gd name="connsiteX4" fmla="*/ 265039 w 491921"/>
                  <a:gd name="connsiteY4" fmla="*/ 450523 h 450762"/>
                  <a:gd name="connsiteX5" fmla="*/ 491541 w 491921"/>
                  <a:gd name="connsiteY5" fmla="*/ 307910 h 450762"/>
                  <a:gd name="connsiteX6" fmla="*/ 323762 w 491921"/>
                  <a:gd name="connsiteY6" fmla="*/ 165297 h 4507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491921" h="450762">
                    <a:moveTo>
                      <a:pt x="323762" y="165297"/>
                    </a:moveTo>
                    <a:cubicBezTo>
                      <a:pt x="280419" y="121954"/>
                      <a:pt x="276224" y="73018"/>
                      <a:pt x="231483" y="47851"/>
                    </a:cubicBezTo>
                    <a:cubicBezTo>
                      <a:pt x="186742" y="22684"/>
                      <a:pt x="91666" y="-23456"/>
                      <a:pt x="55314" y="14295"/>
                    </a:cubicBezTo>
                    <a:cubicBezTo>
                      <a:pt x="18962" y="52046"/>
                      <a:pt x="-21585" y="201649"/>
                      <a:pt x="13369" y="274354"/>
                    </a:cubicBezTo>
                    <a:cubicBezTo>
                      <a:pt x="48323" y="347059"/>
                      <a:pt x="185344" y="444930"/>
                      <a:pt x="265039" y="450523"/>
                    </a:cubicBezTo>
                    <a:cubicBezTo>
                      <a:pt x="344734" y="456116"/>
                      <a:pt x="483152" y="362438"/>
                      <a:pt x="491541" y="307910"/>
                    </a:cubicBezTo>
                    <a:cubicBezTo>
                      <a:pt x="499930" y="253382"/>
                      <a:pt x="367105" y="208640"/>
                      <a:pt x="323762" y="165297"/>
                    </a:cubicBezTo>
                    <a:close/>
                  </a:path>
                </a:pathLst>
              </a:cu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Freeform 185">
                <a:extLst>
                  <a:ext uri="{FF2B5EF4-FFF2-40B4-BE49-F238E27FC236}">
                    <a16:creationId xmlns:a16="http://schemas.microsoft.com/office/drawing/2014/main" id="{81F45B84-B752-4A9A-959B-CB778FE4A2B4}"/>
                  </a:ext>
                </a:extLst>
              </p:cNvPr>
              <p:cNvSpPr/>
              <p:nvPr/>
            </p:nvSpPr>
            <p:spPr>
              <a:xfrm>
                <a:off x="7521922" y="3350808"/>
                <a:ext cx="70969" cy="96486"/>
              </a:xfrm>
              <a:custGeom>
                <a:avLst/>
                <a:gdLst>
                  <a:gd name="connsiteX0" fmla="*/ 75748 w 100915"/>
                  <a:gd name="connsiteY0" fmla="*/ 0 h 142643"/>
                  <a:gd name="connsiteX1" fmla="*/ 58970 w 100915"/>
                  <a:gd name="connsiteY1" fmla="*/ 67112 h 142643"/>
                  <a:gd name="connsiteX2" fmla="*/ 247 w 100915"/>
                  <a:gd name="connsiteY2" fmla="*/ 83890 h 142643"/>
                  <a:gd name="connsiteX3" fmla="*/ 84137 w 100915"/>
                  <a:gd name="connsiteY3" fmla="*/ 142613 h 142643"/>
                  <a:gd name="connsiteX4" fmla="*/ 92526 w 100915"/>
                  <a:gd name="connsiteY4" fmla="*/ 75501 h 142643"/>
                  <a:gd name="connsiteX5" fmla="*/ 100915 w 100915"/>
                  <a:gd name="connsiteY5" fmla="*/ 58723 h 1426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00915" h="142643">
                    <a:moveTo>
                      <a:pt x="75748" y="0"/>
                    </a:moveTo>
                    <a:cubicBezTo>
                      <a:pt x="73650" y="26565"/>
                      <a:pt x="71553" y="53130"/>
                      <a:pt x="58970" y="67112"/>
                    </a:cubicBezTo>
                    <a:cubicBezTo>
                      <a:pt x="46386" y="81094"/>
                      <a:pt x="-3948" y="71306"/>
                      <a:pt x="247" y="83890"/>
                    </a:cubicBezTo>
                    <a:cubicBezTo>
                      <a:pt x="4442" y="96474"/>
                      <a:pt x="68757" y="144011"/>
                      <a:pt x="84137" y="142613"/>
                    </a:cubicBezTo>
                    <a:cubicBezTo>
                      <a:pt x="99517" y="141215"/>
                      <a:pt x="92526" y="75501"/>
                      <a:pt x="92526" y="75501"/>
                    </a:cubicBezTo>
                    <a:cubicBezTo>
                      <a:pt x="95322" y="61519"/>
                      <a:pt x="98118" y="60121"/>
                      <a:pt x="100915" y="58723"/>
                    </a:cubicBezTo>
                  </a:path>
                </a:pathLst>
              </a:cu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Oval 50">
                <a:extLst>
                  <a:ext uri="{FF2B5EF4-FFF2-40B4-BE49-F238E27FC236}">
                    <a16:creationId xmlns:a16="http://schemas.microsoft.com/office/drawing/2014/main" id="{B95DAF0E-351C-4829-9968-D8B510B31792}"/>
                  </a:ext>
                </a:extLst>
              </p:cNvPr>
              <p:cNvSpPr/>
              <p:nvPr/>
            </p:nvSpPr>
            <p:spPr>
              <a:xfrm>
                <a:off x="7452906" y="3443857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Oval 51">
                <a:extLst>
                  <a:ext uri="{FF2B5EF4-FFF2-40B4-BE49-F238E27FC236}">
                    <a16:creationId xmlns:a16="http://schemas.microsoft.com/office/drawing/2014/main" id="{5AFEEBBE-9126-46D2-A7C9-A3021E51264D}"/>
                  </a:ext>
                </a:extLst>
              </p:cNvPr>
              <p:cNvSpPr/>
              <p:nvPr/>
            </p:nvSpPr>
            <p:spPr>
              <a:xfrm>
                <a:off x="7560083" y="3524245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Oval 52">
                <a:extLst>
                  <a:ext uri="{FF2B5EF4-FFF2-40B4-BE49-F238E27FC236}">
                    <a16:creationId xmlns:a16="http://schemas.microsoft.com/office/drawing/2014/main" id="{6489E8FC-7465-44A2-82B7-564AE6DD7729}"/>
                  </a:ext>
                </a:extLst>
              </p:cNvPr>
              <p:cNvSpPr/>
              <p:nvPr/>
            </p:nvSpPr>
            <p:spPr>
              <a:xfrm>
                <a:off x="7560083" y="3473176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Oval 53">
                <a:extLst>
                  <a:ext uri="{FF2B5EF4-FFF2-40B4-BE49-F238E27FC236}">
                    <a16:creationId xmlns:a16="http://schemas.microsoft.com/office/drawing/2014/main" id="{68520D18-ACD9-4B0A-B874-A5B2220C2841}"/>
                  </a:ext>
                </a:extLst>
              </p:cNvPr>
              <p:cNvSpPr/>
              <p:nvPr/>
            </p:nvSpPr>
            <p:spPr>
              <a:xfrm>
                <a:off x="7672175" y="3490198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Oval 54">
                <a:extLst>
                  <a:ext uri="{FF2B5EF4-FFF2-40B4-BE49-F238E27FC236}">
                    <a16:creationId xmlns:a16="http://schemas.microsoft.com/office/drawing/2014/main" id="{A635E2A5-8782-427B-B68A-F3D83C9AB92B}"/>
                  </a:ext>
                </a:extLst>
              </p:cNvPr>
              <p:cNvSpPr/>
              <p:nvPr/>
            </p:nvSpPr>
            <p:spPr>
              <a:xfrm>
                <a:off x="7447989" y="3342662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Freeform 191">
                <a:extLst>
                  <a:ext uri="{FF2B5EF4-FFF2-40B4-BE49-F238E27FC236}">
                    <a16:creationId xmlns:a16="http://schemas.microsoft.com/office/drawing/2014/main" id="{781FBD94-AA98-4655-B8A0-1954BCC860FC}"/>
                  </a:ext>
                </a:extLst>
              </p:cNvPr>
              <p:cNvSpPr/>
              <p:nvPr/>
            </p:nvSpPr>
            <p:spPr>
              <a:xfrm>
                <a:off x="7788145" y="3420487"/>
                <a:ext cx="235419" cy="197941"/>
              </a:xfrm>
              <a:custGeom>
                <a:avLst/>
                <a:gdLst>
                  <a:gd name="connsiteX0" fmla="*/ 334754 w 334754"/>
                  <a:gd name="connsiteY0" fmla="*/ 73157 h 292632"/>
                  <a:gd name="connsiteX1" fmla="*/ 292809 w 334754"/>
                  <a:gd name="connsiteY1" fmla="*/ 182214 h 292632"/>
                  <a:gd name="connsiteX2" fmla="*/ 225697 w 334754"/>
                  <a:gd name="connsiteY2" fmla="*/ 31212 h 292632"/>
                  <a:gd name="connsiteX3" fmla="*/ 7583 w 334754"/>
                  <a:gd name="connsiteY3" fmla="*/ 22823 h 292632"/>
                  <a:gd name="connsiteX4" fmla="*/ 66306 w 334754"/>
                  <a:gd name="connsiteY4" fmla="*/ 282882 h 292632"/>
                  <a:gd name="connsiteX5" fmla="*/ 225697 w 334754"/>
                  <a:gd name="connsiteY5" fmla="*/ 240937 h 292632"/>
                  <a:gd name="connsiteX6" fmla="*/ 242475 w 334754"/>
                  <a:gd name="connsiteY6" fmla="*/ 274493 h 2926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334754" h="292632">
                    <a:moveTo>
                      <a:pt x="334754" y="73157"/>
                    </a:moveTo>
                    <a:cubicBezTo>
                      <a:pt x="322869" y="131181"/>
                      <a:pt x="310985" y="189205"/>
                      <a:pt x="292809" y="182214"/>
                    </a:cubicBezTo>
                    <a:cubicBezTo>
                      <a:pt x="274633" y="175223"/>
                      <a:pt x="273235" y="57777"/>
                      <a:pt x="225697" y="31212"/>
                    </a:cubicBezTo>
                    <a:cubicBezTo>
                      <a:pt x="178159" y="4647"/>
                      <a:pt x="34148" y="-19122"/>
                      <a:pt x="7583" y="22823"/>
                    </a:cubicBezTo>
                    <a:cubicBezTo>
                      <a:pt x="-18982" y="64768"/>
                      <a:pt x="29954" y="246530"/>
                      <a:pt x="66306" y="282882"/>
                    </a:cubicBezTo>
                    <a:cubicBezTo>
                      <a:pt x="102658" y="319234"/>
                      <a:pt x="196336" y="242335"/>
                      <a:pt x="225697" y="240937"/>
                    </a:cubicBezTo>
                    <a:cubicBezTo>
                      <a:pt x="255058" y="239539"/>
                      <a:pt x="248766" y="257016"/>
                      <a:pt x="242475" y="274493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Oval 56">
                <a:extLst>
                  <a:ext uri="{FF2B5EF4-FFF2-40B4-BE49-F238E27FC236}">
                    <a16:creationId xmlns:a16="http://schemas.microsoft.com/office/drawing/2014/main" id="{EEFC9030-AA8B-428E-B732-0BC10581C6C3}"/>
                  </a:ext>
                </a:extLst>
              </p:cNvPr>
              <p:cNvSpPr/>
              <p:nvPr/>
            </p:nvSpPr>
            <p:spPr>
              <a:xfrm>
                <a:off x="7838349" y="3513843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Oval 57">
                <a:extLst>
                  <a:ext uri="{FF2B5EF4-FFF2-40B4-BE49-F238E27FC236}">
                    <a16:creationId xmlns:a16="http://schemas.microsoft.com/office/drawing/2014/main" id="{391837CD-EA76-4D9F-A770-1FFF8332FB79}"/>
                  </a:ext>
                </a:extLst>
              </p:cNvPr>
              <p:cNvSpPr/>
              <p:nvPr/>
            </p:nvSpPr>
            <p:spPr>
              <a:xfrm>
                <a:off x="7838349" y="3462772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Oval 58">
                <a:extLst>
                  <a:ext uri="{FF2B5EF4-FFF2-40B4-BE49-F238E27FC236}">
                    <a16:creationId xmlns:a16="http://schemas.microsoft.com/office/drawing/2014/main" id="{052422F2-D7E6-426A-9074-474179B97C35}"/>
                  </a:ext>
                </a:extLst>
              </p:cNvPr>
              <p:cNvSpPr/>
              <p:nvPr/>
            </p:nvSpPr>
            <p:spPr>
              <a:xfrm>
                <a:off x="8140491" y="3406622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" name="Oval 59">
                <a:extLst>
                  <a:ext uri="{FF2B5EF4-FFF2-40B4-BE49-F238E27FC236}">
                    <a16:creationId xmlns:a16="http://schemas.microsoft.com/office/drawing/2014/main" id="{3F2A0F3D-3D76-408A-A20B-9C7B87DFA50D}"/>
                  </a:ext>
                </a:extLst>
              </p:cNvPr>
              <p:cNvSpPr/>
              <p:nvPr/>
            </p:nvSpPr>
            <p:spPr>
              <a:xfrm>
                <a:off x="8247668" y="3509707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Oval 60">
                <a:extLst>
                  <a:ext uri="{FF2B5EF4-FFF2-40B4-BE49-F238E27FC236}">
                    <a16:creationId xmlns:a16="http://schemas.microsoft.com/office/drawing/2014/main" id="{D46963DA-1072-45CD-AB52-AAFB7E30EA3D}"/>
                  </a:ext>
                </a:extLst>
              </p:cNvPr>
              <p:cNvSpPr/>
              <p:nvPr/>
            </p:nvSpPr>
            <p:spPr>
              <a:xfrm>
                <a:off x="8279829" y="3298972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Oval 61">
                <a:extLst>
                  <a:ext uri="{FF2B5EF4-FFF2-40B4-BE49-F238E27FC236}">
                    <a16:creationId xmlns:a16="http://schemas.microsoft.com/office/drawing/2014/main" id="{DF93E4FD-DF80-419C-80F6-CFD99CF7EF05}"/>
                  </a:ext>
                </a:extLst>
              </p:cNvPr>
              <p:cNvSpPr/>
              <p:nvPr/>
            </p:nvSpPr>
            <p:spPr>
              <a:xfrm>
                <a:off x="8395702" y="3466343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Oval 62">
                <a:extLst>
                  <a:ext uri="{FF2B5EF4-FFF2-40B4-BE49-F238E27FC236}">
                    <a16:creationId xmlns:a16="http://schemas.microsoft.com/office/drawing/2014/main" id="{16CBB7B7-9C75-4AEB-A5CB-606A9894E0B5}"/>
                  </a:ext>
                </a:extLst>
              </p:cNvPr>
              <p:cNvSpPr/>
              <p:nvPr/>
            </p:nvSpPr>
            <p:spPr>
              <a:xfrm>
                <a:off x="8354845" y="3385815"/>
                <a:ext cx="80990" cy="546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C8EA35A0-D4BA-41A6-8607-EAA7C47188EA}"/>
                  </a:ext>
                </a:extLst>
              </p:cNvPr>
              <p:cNvSpPr txBox="1"/>
              <p:nvPr/>
            </p:nvSpPr>
            <p:spPr>
              <a:xfrm>
                <a:off x="8285708" y="3556475"/>
                <a:ext cx="17745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Exosome-secretion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329B17FA-AC62-4289-BD6B-C77507EBA630}"/>
                  </a:ext>
                </a:extLst>
              </p:cNvPr>
              <p:cNvSpPr txBox="1"/>
              <p:nvPr/>
            </p:nvSpPr>
            <p:spPr>
              <a:xfrm>
                <a:off x="7692752" y="2910143"/>
                <a:ext cx="9471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Endosome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C13B66BB-9CD7-4003-AC94-8F0D40FFF88C}"/>
                  </a:ext>
                </a:extLst>
              </p:cNvPr>
              <p:cNvSpPr txBox="1"/>
              <p:nvPr/>
            </p:nvSpPr>
            <p:spPr>
              <a:xfrm>
                <a:off x="7185563" y="3580940"/>
                <a:ext cx="578850" cy="2379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MVB</a:t>
                </a:r>
              </a:p>
            </p:txBody>
          </p:sp>
          <p:sp>
            <p:nvSpPr>
              <p:cNvPr id="67" name="Freeform 202">
                <a:extLst>
                  <a:ext uri="{FF2B5EF4-FFF2-40B4-BE49-F238E27FC236}">
                    <a16:creationId xmlns:a16="http://schemas.microsoft.com/office/drawing/2014/main" id="{314CABF7-2C42-4830-86A9-F69F7E8FA544}"/>
                  </a:ext>
                </a:extLst>
              </p:cNvPr>
              <p:cNvSpPr/>
              <p:nvPr/>
            </p:nvSpPr>
            <p:spPr>
              <a:xfrm flipH="1">
                <a:off x="7474899" y="2967983"/>
                <a:ext cx="32152" cy="121800"/>
              </a:xfrm>
              <a:custGeom>
                <a:avLst/>
                <a:gdLst>
                  <a:gd name="connsiteX0" fmla="*/ 8389 w 8389"/>
                  <a:gd name="connsiteY0" fmla="*/ 0 h 125834"/>
                  <a:gd name="connsiteX1" fmla="*/ 0 w 8389"/>
                  <a:gd name="connsiteY1" fmla="*/ 125834 h 1258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389" h="125834">
                    <a:moveTo>
                      <a:pt x="8389" y="0"/>
                    </a:moveTo>
                    <a:lnTo>
                      <a:pt x="0" y="125834"/>
                    </a:lnTo>
                  </a:path>
                </a:pathLst>
              </a:custGeom>
              <a:noFill/>
              <a:ln>
                <a:prstDash val="sysDash"/>
                <a:tailEnd type="stealt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" name="Freeform 203">
                <a:extLst>
                  <a:ext uri="{FF2B5EF4-FFF2-40B4-BE49-F238E27FC236}">
                    <a16:creationId xmlns:a16="http://schemas.microsoft.com/office/drawing/2014/main" id="{808C30A3-B473-44F3-9AF2-0810B8E7FEBB}"/>
                  </a:ext>
                </a:extLst>
              </p:cNvPr>
              <p:cNvSpPr/>
              <p:nvPr/>
            </p:nvSpPr>
            <p:spPr>
              <a:xfrm>
                <a:off x="7581092" y="3271366"/>
                <a:ext cx="589961" cy="300766"/>
              </a:xfrm>
              <a:custGeom>
                <a:avLst/>
                <a:gdLst>
                  <a:gd name="connsiteX0" fmla="*/ 0 w 838899"/>
                  <a:gd name="connsiteY0" fmla="*/ 0 h 444647"/>
                  <a:gd name="connsiteX1" fmla="*/ 33556 w 838899"/>
                  <a:gd name="connsiteY1" fmla="*/ 167780 h 444647"/>
                  <a:gd name="connsiteX2" fmla="*/ 201336 w 838899"/>
                  <a:gd name="connsiteY2" fmla="*/ 318782 h 444647"/>
                  <a:gd name="connsiteX3" fmla="*/ 494950 w 838899"/>
                  <a:gd name="connsiteY3" fmla="*/ 343949 h 444647"/>
                  <a:gd name="connsiteX4" fmla="*/ 604007 w 838899"/>
                  <a:gd name="connsiteY4" fmla="*/ 444617 h 444647"/>
                  <a:gd name="connsiteX5" fmla="*/ 838899 w 838899"/>
                  <a:gd name="connsiteY5" fmla="*/ 352338 h 444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838899" h="444647">
                    <a:moveTo>
                      <a:pt x="0" y="0"/>
                    </a:moveTo>
                    <a:cubicBezTo>
                      <a:pt x="0" y="57325"/>
                      <a:pt x="0" y="114650"/>
                      <a:pt x="33556" y="167780"/>
                    </a:cubicBezTo>
                    <a:cubicBezTo>
                      <a:pt x="67112" y="220910"/>
                      <a:pt x="124437" y="289421"/>
                      <a:pt x="201336" y="318782"/>
                    </a:cubicBezTo>
                    <a:cubicBezTo>
                      <a:pt x="278235" y="348143"/>
                      <a:pt x="427838" y="322977"/>
                      <a:pt x="494950" y="343949"/>
                    </a:cubicBezTo>
                    <a:cubicBezTo>
                      <a:pt x="562062" y="364921"/>
                      <a:pt x="546682" y="443219"/>
                      <a:pt x="604007" y="444617"/>
                    </a:cubicBezTo>
                    <a:cubicBezTo>
                      <a:pt x="661332" y="446015"/>
                      <a:pt x="750115" y="399176"/>
                      <a:pt x="838899" y="352338"/>
                    </a:cubicBezTo>
                  </a:path>
                </a:pathLst>
              </a:custGeom>
              <a:noFill/>
              <a:ln>
                <a:prstDash val="sysDash"/>
                <a:tailEnd type="stealt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id="{082ED9BE-D8B5-46DD-9399-1990636D55BE}"/>
                  </a:ext>
                </a:extLst>
              </p:cNvPr>
              <p:cNvCxnSpPr/>
              <p:nvPr/>
            </p:nvCxnSpPr>
            <p:spPr>
              <a:xfrm flipH="1">
                <a:off x="7751532" y="3073690"/>
                <a:ext cx="44916" cy="87317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Arrow Connector 69">
                <a:extLst>
                  <a:ext uri="{FF2B5EF4-FFF2-40B4-BE49-F238E27FC236}">
                    <a16:creationId xmlns:a16="http://schemas.microsoft.com/office/drawing/2014/main" id="{039A2186-4E19-40CD-A7B0-ED99C4A97460}"/>
                  </a:ext>
                </a:extLst>
              </p:cNvPr>
              <p:cNvCxnSpPr/>
              <p:nvPr/>
            </p:nvCxnSpPr>
            <p:spPr>
              <a:xfrm flipV="1">
                <a:off x="7362673" y="3505755"/>
                <a:ext cx="76897" cy="15962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F7B8310-316C-43E7-8462-8873D3A80F01}"/>
                </a:ext>
              </a:extLst>
            </p:cNvPr>
            <p:cNvSpPr txBox="1"/>
            <p:nvPr/>
          </p:nvSpPr>
          <p:spPr>
            <a:xfrm>
              <a:off x="7382379" y="4270963"/>
              <a:ext cx="519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chemeClr val="bg1"/>
                  </a:solidFill>
                </a:rPr>
                <a:t>Nu</a:t>
              </a:r>
            </a:p>
          </p:txBody>
        </p:sp>
        <p:cxnSp>
          <p:nvCxnSpPr>
            <p:cNvPr id="72" name="Straight Arrow Connector 71">
              <a:extLst>
                <a:ext uri="{FF2B5EF4-FFF2-40B4-BE49-F238E27FC236}">
                  <a16:creationId xmlns:a16="http://schemas.microsoft.com/office/drawing/2014/main" id="{8C77AAF0-56DE-42D3-8D0F-8B99DDF5834D}"/>
                </a:ext>
              </a:extLst>
            </p:cNvPr>
            <p:cNvCxnSpPr/>
            <p:nvPr/>
          </p:nvCxnSpPr>
          <p:spPr>
            <a:xfrm flipH="1" flipV="1">
              <a:off x="8707929" y="4639825"/>
              <a:ext cx="15986" cy="1530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55F57236-6EEA-42C9-926C-50096E32E65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82861" y="3920737"/>
              <a:ext cx="2185535" cy="1000433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E1E88A5-03FF-4B5C-8562-AAB9F5977E0E}"/>
                </a:ext>
              </a:extLst>
            </p:cNvPr>
            <p:cNvSpPr txBox="1"/>
            <p:nvPr/>
          </p:nvSpPr>
          <p:spPr>
            <a:xfrm>
              <a:off x="5136825" y="4732204"/>
              <a:ext cx="10260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chemeClr val="bg1"/>
                  </a:solidFill>
                </a:rPr>
                <a:t>Exo</a:t>
              </a:r>
              <a:r>
                <a:rPr lang="en-US" sz="1200" b="1" dirty="0">
                  <a:solidFill>
                    <a:schemeClr val="bg1"/>
                  </a:solidFill>
                </a:rPr>
                <a:t>-</a:t>
              </a:r>
              <a:r>
                <a:rPr lang="en-US" sz="1200" b="1" dirty="0" err="1">
                  <a:solidFill>
                    <a:schemeClr val="bg1"/>
                  </a:solidFill>
                </a:rPr>
                <a:t>gLuc</a:t>
              </a:r>
              <a:r>
                <a:rPr lang="en-US" sz="1200" b="1" dirty="0">
                  <a:solidFill>
                    <a:schemeClr val="bg1"/>
                  </a:solidFill>
                </a:rPr>
                <a:t>-RFP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A11590B8-49BC-4DA1-8C21-D3B9918607E7}"/>
                </a:ext>
              </a:extLst>
            </p:cNvPr>
            <p:cNvCxnSpPr/>
            <p:nvPr/>
          </p:nvCxnSpPr>
          <p:spPr>
            <a:xfrm>
              <a:off x="5383218" y="4324389"/>
              <a:ext cx="64137" cy="193128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1637E31-9059-4F70-82A5-8C45062CCBF9}"/>
                </a:ext>
              </a:extLst>
            </p:cNvPr>
            <p:cNvSpPr txBox="1"/>
            <p:nvPr/>
          </p:nvSpPr>
          <p:spPr>
            <a:xfrm>
              <a:off x="5029319" y="4037454"/>
              <a:ext cx="8230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Exosome</a:t>
              </a: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BEDC9A60-71E3-4954-AAF1-D8F09C88CB3B}"/>
                </a:ext>
              </a:extLst>
            </p:cNvPr>
            <p:cNvCxnSpPr/>
            <p:nvPr/>
          </p:nvCxnSpPr>
          <p:spPr>
            <a:xfrm>
              <a:off x="6904975" y="3974685"/>
              <a:ext cx="348105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49AB42C9-4D3E-40CC-8543-027E9B182444}"/>
                </a:ext>
              </a:extLst>
            </p:cNvPr>
            <p:cNvCxnSpPr/>
            <p:nvPr/>
          </p:nvCxnSpPr>
          <p:spPr>
            <a:xfrm>
              <a:off x="5737815" y="3988069"/>
              <a:ext cx="370692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CD70B89-0CB6-4FF5-B548-5691E6FDD18D}"/>
                </a:ext>
              </a:extLst>
            </p:cNvPr>
            <p:cNvSpPr txBox="1"/>
            <p:nvPr/>
          </p:nvSpPr>
          <p:spPr>
            <a:xfrm>
              <a:off x="6128940" y="6037082"/>
              <a:ext cx="1078810" cy="307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RFP + TLI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DB269348-E609-4FB3-A860-5B18B87D6F99}"/>
                </a:ext>
              </a:extLst>
            </p:cNvPr>
            <p:cNvSpPr txBox="1"/>
            <p:nvPr/>
          </p:nvSpPr>
          <p:spPr>
            <a:xfrm>
              <a:off x="5222689" y="6036993"/>
              <a:ext cx="5583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RFP</a:t>
              </a:r>
            </a:p>
          </p:txBody>
        </p: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52884420-CBCB-4D40-B048-FAD9A6772A9F}"/>
                </a:ext>
              </a:extLst>
            </p:cNvPr>
            <p:cNvGrpSpPr/>
            <p:nvPr/>
          </p:nvGrpSpPr>
          <p:grpSpPr>
            <a:xfrm>
              <a:off x="7307789" y="5136296"/>
              <a:ext cx="3196925" cy="974123"/>
              <a:chOff x="6966313" y="3887510"/>
              <a:chExt cx="3196925" cy="974123"/>
            </a:xfrm>
          </p:grpSpPr>
          <p:sp>
            <p:nvSpPr>
              <p:cNvPr id="82" name="Oval 81">
                <a:extLst>
                  <a:ext uri="{FF2B5EF4-FFF2-40B4-BE49-F238E27FC236}">
                    <a16:creationId xmlns:a16="http://schemas.microsoft.com/office/drawing/2014/main" id="{398C9598-A601-42AC-9AD4-CE30A3A053DB}"/>
                  </a:ext>
                </a:extLst>
              </p:cNvPr>
              <p:cNvSpPr/>
              <p:nvPr/>
            </p:nvSpPr>
            <p:spPr>
              <a:xfrm>
                <a:off x="6966313" y="3887510"/>
                <a:ext cx="1081474" cy="974123"/>
              </a:xfrm>
              <a:prstGeom prst="ellipse">
                <a:avLst/>
              </a:prstGeom>
              <a:solidFill>
                <a:srgbClr val="FF0000"/>
              </a:solidFill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3" name="Oval 82">
                <a:extLst>
                  <a:ext uri="{FF2B5EF4-FFF2-40B4-BE49-F238E27FC236}">
                    <a16:creationId xmlns:a16="http://schemas.microsoft.com/office/drawing/2014/main" id="{7CAB6069-0995-4FEF-9943-3505DBDB7684}"/>
                  </a:ext>
                </a:extLst>
              </p:cNvPr>
              <p:cNvSpPr/>
              <p:nvPr/>
            </p:nvSpPr>
            <p:spPr>
              <a:xfrm>
                <a:off x="7040981" y="4088983"/>
                <a:ext cx="466070" cy="541300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i="1" dirty="0"/>
              </a:p>
            </p:txBody>
          </p:sp>
          <p:sp>
            <p:nvSpPr>
              <p:cNvPr id="84" name="Freeform 111">
                <a:extLst>
                  <a:ext uri="{FF2B5EF4-FFF2-40B4-BE49-F238E27FC236}">
                    <a16:creationId xmlns:a16="http://schemas.microsoft.com/office/drawing/2014/main" id="{3AAFEB8B-88FE-424B-B11C-2B195D5DFFC2}"/>
                  </a:ext>
                </a:extLst>
              </p:cNvPr>
              <p:cNvSpPr/>
              <p:nvPr/>
            </p:nvSpPr>
            <p:spPr>
              <a:xfrm>
                <a:off x="7396394" y="4105796"/>
                <a:ext cx="206110" cy="579075"/>
              </a:xfrm>
              <a:custGeom>
                <a:avLst/>
                <a:gdLst>
                  <a:gd name="connsiteX0" fmla="*/ 140063 w 293078"/>
                  <a:gd name="connsiteY0" fmla="*/ 310 h 856094"/>
                  <a:gd name="connsiteX1" fmla="*/ 89729 w 293078"/>
                  <a:gd name="connsiteY1" fmla="*/ 59033 h 856094"/>
                  <a:gd name="connsiteX2" fmla="*/ 198786 w 293078"/>
                  <a:gd name="connsiteY2" fmla="*/ 142923 h 856094"/>
                  <a:gd name="connsiteX3" fmla="*/ 223953 w 293078"/>
                  <a:gd name="connsiteY3" fmla="*/ 453316 h 856094"/>
                  <a:gd name="connsiteX4" fmla="*/ 156841 w 293078"/>
                  <a:gd name="connsiteY4" fmla="*/ 621096 h 856094"/>
                  <a:gd name="connsiteX5" fmla="*/ 31006 w 293078"/>
                  <a:gd name="connsiteY5" fmla="*/ 763709 h 856094"/>
                  <a:gd name="connsiteX6" fmla="*/ 31006 w 293078"/>
                  <a:gd name="connsiteY6" fmla="*/ 763709 h 856094"/>
                  <a:gd name="connsiteX7" fmla="*/ 5839 w 293078"/>
                  <a:gd name="connsiteY7" fmla="*/ 855988 h 856094"/>
                  <a:gd name="connsiteX8" fmla="*/ 156841 w 293078"/>
                  <a:gd name="connsiteY8" fmla="*/ 780487 h 856094"/>
                  <a:gd name="connsiteX9" fmla="*/ 165230 w 293078"/>
                  <a:gd name="connsiteY9" fmla="*/ 704986 h 856094"/>
                  <a:gd name="connsiteX10" fmla="*/ 223953 w 293078"/>
                  <a:gd name="connsiteY10" fmla="*/ 570762 h 856094"/>
                  <a:gd name="connsiteX11" fmla="*/ 274287 w 293078"/>
                  <a:gd name="connsiteY11" fmla="*/ 394593 h 856094"/>
                  <a:gd name="connsiteX12" fmla="*/ 291065 w 293078"/>
                  <a:gd name="connsiteY12" fmla="*/ 268758 h 856094"/>
                  <a:gd name="connsiteX13" fmla="*/ 232342 w 293078"/>
                  <a:gd name="connsiteY13" fmla="*/ 126145 h 856094"/>
                  <a:gd name="connsiteX14" fmla="*/ 190397 w 293078"/>
                  <a:gd name="connsiteY14" fmla="*/ 8699 h 856094"/>
                  <a:gd name="connsiteX15" fmla="*/ 89729 w 293078"/>
                  <a:gd name="connsiteY15" fmla="*/ 8699 h 856094"/>
                  <a:gd name="connsiteX16" fmla="*/ 89729 w 293078"/>
                  <a:gd name="connsiteY16" fmla="*/ 8699 h 8560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293078" h="856094">
                    <a:moveTo>
                      <a:pt x="140063" y="310"/>
                    </a:moveTo>
                    <a:cubicBezTo>
                      <a:pt x="110002" y="17787"/>
                      <a:pt x="79942" y="35264"/>
                      <a:pt x="89729" y="59033"/>
                    </a:cubicBezTo>
                    <a:cubicBezTo>
                      <a:pt x="99516" y="82802"/>
                      <a:pt x="176415" y="77209"/>
                      <a:pt x="198786" y="142923"/>
                    </a:cubicBezTo>
                    <a:cubicBezTo>
                      <a:pt x="221157" y="208637"/>
                      <a:pt x="230944" y="373621"/>
                      <a:pt x="223953" y="453316"/>
                    </a:cubicBezTo>
                    <a:cubicBezTo>
                      <a:pt x="216962" y="533011"/>
                      <a:pt x="188999" y="569364"/>
                      <a:pt x="156841" y="621096"/>
                    </a:cubicBezTo>
                    <a:cubicBezTo>
                      <a:pt x="124683" y="672828"/>
                      <a:pt x="31006" y="763709"/>
                      <a:pt x="31006" y="763709"/>
                    </a:cubicBezTo>
                    <a:lnTo>
                      <a:pt x="31006" y="763709"/>
                    </a:lnTo>
                    <a:cubicBezTo>
                      <a:pt x="26811" y="779089"/>
                      <a:pt x="-15134" y="853192"/>
                      <a:pt x="5839" y="855988"/>
                    </a:cubicBezTo>
                    <a:cubicBezTo>
                      <a:pt x="26811" y="858784"/>
                      <a:pt x="130276" y="805654"/>
                      <a:pt x="156841" y="780487"/>
                    </a:cubicBezTo>
                    <a:cubicBezTo>
                      <a:pt x="183406" y="755320"/>
                      <a:pt x="154045" y="739940"/>
                      <a:pt x="165230" y="704986"/>
                    </a:cubicBezTo>
                    <a:cubicBezTo>
                      <a:pt x="176415" y="670032"/>
                      <a:pt x="205777" y="622494"/>
                      <a:pt x="223953" y="570762"/>
                    </a:cubicBezTo>
                    <a:cubicBezTo>
                      <a:pt x="242129" y="519030"/>
                      <a:pt x="263102" y="444927"/>
                      <a:pt x="274287" y="394593"/>
                    </a:cubicBezTo>
                    <a:cubicBezTo>
                      <a:pt x="285472" y="344259"/>
                      <a:pt x="298056" y="313499"/>
                      <a:pt x="291065" y="268758"/>
                    </a:cubicBezTo>
                    <a:cubicBezTo>
                      <a:pt x="284074" y="224017"/>
                      <a:pt x="249120" y="169488"/>
                      <a:pt x="232342" y="126145"/>
                    </a:cubicBezTo>
                    <a:cubicBezTo>
                      <a:pt x="215564" y="82802"/>
                      <a:pt x="214166" y="28273"/>
                      <a:pt x="190397" y="8699"/>
                    </a:cubicBezTo>
                    <a:cubicBezTo>
                      <a:pt x="166628" y="-10875"/>
                      <a:pt x="89729" y="8699"/>
                      <a:pt x="89729" y="8699"/>
                    </a:cubicBezTo>
                    <a:lnTo>
                      <a:pt x="89729" y="8699"/>
                    </a:lnTo>
                  </a:path>
                </a:pathLst>
              </a:cu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Freeform 112">
                <a:extLst>
                  <a:ext uri="{FF2B5EF4-FFF2-40B4-BE49-F238E27FC236}">
                    <a16:creationId xmlns:a16="http://schemas.microsoft.com/office/drawing/2014/main" id="{FF24003F-8EB2-47B2-8087-AB41AE853EB4}"/>
                  </a:ext>
                </a:extLst>
              </p:cNvPr>
              <p:cNvSpPr/>
              <p:nvPr/>
            </p:nvSpPr>
            <p:spPr>
              <a:xfrm>
                <a:off x="7548935" y="4131799"/>
                <a:ext cx="120604" cy="565210"/>
              </a:xfrm>
              <a:custGeom>
                <a:avLst/>
                <a:gdLst>
                  <a:gd name="connsiteX0" fmla="*/ 94592 w 227293"/>
                  <a:gd name="connsiteY0" fmla="*/ 20169 h 835597"/>
                  <a:gd name="connsiteX1" fmla="*/ 44258 w 227293"/>
                  <a:gd name="connsiteY1" fmla="*/ 36947 h 835597"/>
                  <a:gd name="connsiteX2" fmla="*/ 161704 w 227293"/>
                  <a:gd name="connsiteY2" fmla="*/ 305395 h 835597"/>
                  <a:gd name="connsiteX3" fmla="*/ 2313 w 227293"/>
                  <a:gd name="connsiteY3" fmla="*/ 699678 h 835597"/>
                  <a:gd name="connsiteX4" fmla="*/ 69425 w 227293"/>
                  <a:gd name="connsiteY4" fmla="*/ 833902 h 835597"/>
                  <a:gd name="connsiteX5" fmla="*/ 102981 w 227293"/>
                  <a:gd name="connsiteY5" fmla="*/ 624177 h 835597"/>
                  <a:gd name="connsiteX6" fmla="*/ 203649 w 227293"/>
                  <a:gd name="connsiteY6" fmla="*/ 431230 h 835597"/>
                  <a:gd name="connsiteX7" fmla="*/ 220427 w 227293"/>
                  <a:gd name="connsiteY7" fmla="*/ 204727 h 835597"/>
                  <a:gd name="connsiteX8" fmla="*/ 94592 w 227293"/>
                  <a:gd name="connsiteY8" fmla="*/ 20169 h 835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27293" h="835597">
                    <a:moveTo>
                      <a:pt x="94592" y="20169"/>
                    </a:moveTo>
                    <a:cubicBezTo>
                      <a:pt x="65231" y="-7794"/>
                      <a:pt x="33073" y="-10591"/>
                      <a:pt x="44258" y="36947"/>
                    </a:cubicBezTo>
                    <a:cubicBezTo>
                      <a:pt x="55443" y="84485"/>
                      <a:pt x="168695" y="194940"/>
                      <a:pt x="161704" y="305395"/>
                    </a:cubicBezTo>
                    <a:cubicBezTo>
                      <a:pt x="154713" y="415850"/>
                      <a:pt x="17693" y="611594"/>
                      <a:pt x="2313" y="699678"/>
                    </a:cubicBezTo>
                    <a:cubicBezTo>
                      <a:pt x="-13067" y="787762"/>
                      <a:pt x="52647" y="846486"/>
                      <a:pt x="69425" y="833902"/>
                    </a:cubicBezTo>
                    <a:cubicBezTo>
                      <a:pt x="86203" y="821319"/>
                      <a:pt x="80610" y="691289"/>
                      <a:pt x="102981" y="624177"/>
                    </a:cubicBezTo>
                    <a:cubicBezTo>
                      <a:pt x="125352" y="557065"/>
                      <a:pt x="184075" y="501138"/>
                      <a:pt x="203649" y="431230"/>
                    </a:cubicBezTo>
                    <a:cubicBezTo>
                      <a:pt x="223223" y="361322"/>
                      <a:pt x="235807" y="267645"/>
                      <a:pt x="220427" y="204727"/>
                    </a:cubicBezTo>
                    <a:cubicBezTo>
                      <a:pt x="205047" y="141810"/>
                      <a:pt x="123953" y="48132"/>
                      <a:pt x="94592" y="20169"/>
                    </a:cubicBezTo>
                    <a:close/>
                  </a:path>
                </a:pathLst>
              </a:custGeom>
              <a:solidFill>
                <a:schemeClr val="accent3">
                  <a:lumMod val="20000"/>
                  <a:lumOff val="8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6" name="Freeform 115">
                <a:extLst>
                  <a:ext uri="{FF2B5EF4-FFF2-40B4-BE49-F238E27FC236}">
                    <a16:creationId xmlns:a16="http://schemas.microsoft.com/office/drawing/2014/main" id="{F6DA054B-916B-4ED3-98E4-64127538DA99}"/>
                  </a:ext>
                </a:extLst>
              </p:cNvPr>
              <p:cNvSpPr/>
              <p:nvPr/>
            </p:nvSpPr>
            <p:spPr>
              <a:xfrm>
                <a:off x="7635781" y="4155463"/>
                <a:ext cx="119264" cy="505281"/>
              </a:xfrm>
              <a:custGeom>
                <a:avLst/>
                <a:gdLst>
                  <a:gd name="connsiteX0" fmla="*/ 94592 w 227293"/>
                  <a:gd name="connsiteY0" fmla="*/ 20169 h 835597"/>
                  <a:gd name="connsiteX1" fmla="*/ 44258 w 227293"/>
                  <a:gd name="connsiteY1" fmla="*/ 36947 h 835597"/>
                  <a:gd name="connsiteX2" fmla="*/ 161704 w 227293"/>
                  <a:gd name="connsiteY2" fmla="*/ 305395 h 835597"/>
                  <a:gd name="connsiteX3" fmla="*/ 2313 w 227293"/>
                  <a:gd name="connsiteY3" fmla="*/ 699678 h 835597"/>
                  <a:gd name="connsiteX4" fmla="*/ 69425 w 227293"/>
                  <a:gd name="connsiteY4" fmla="*/ 833902 h 835597"/>
                  <a:gd name="connsiteX5" fmla="*/ 102981 w 227293"/>
                  <a:gd name="connsiteY5" fmla="*/ 624177 h 835597"/>
                  <a:gd name="connsiteX6" fmla="*/ 203649 w 227293"/>
                  <a:gd name="connsiteY6" fmla="*/ 431230 h 835597"/>
                  <a:gd name="connsiteX7" fmla="*/ 220427 w 227293"/>
                  <a:gd name="connsiteY7" fmla="*/ 204727 h 835597"/>
                  <a:gd name="connsiteX8" fmla="*/ 94592 w 227293"/>
                  <a:gd name="connsiteY8" fmla="*/ 20169 h 835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27293" h="835597">
                    <a:moveTo>
                      <a:pt x="94592" y="20169"/>
                    </a:moveTo>
                    <a:cubicBezTo>
                      <a:pt x="65231" y="-7794"/>
                      <a:pt x="33073" y="-10591"/>
                      <a:pt x="44258" y="36947"/>
                    </a:cubicBezTo>
                    <a:cubicBezTo>
                      <a:pt x="55443" y="84485"/>
                      <a:pt x="168695" y="194940"/>
                      <a:pt x="161704" y="305395"/>
                    </a:cubicBezTo>
                    <a:cubicBezTo>
                      <a:pt x="154713" y="415850"/>
                      <a:pt x="17693" y="611594"/>
                      <a:pt x="2313" y="699678"/>
                    </a:cubicBezTo>
                    <a:cubicBezTo>
                      <a:pt x="-13067" y="787762"/>
                      <a:pt x="52647" y="846486"/>
                      <a:pt x="69425" y="833902"/>
                    </a:cubicBezTo>
                    <a:cubicBezTo>
                      <a:pt x="86203" y="821319"/>
                      <a:pt x="80610" y="691289"/>
                      <a:pt x="102981" y="624177"/>
                    </a:cubicBezTo>
                    <a:cubicBezTo>
                      <a:pt x="125352" y="557065"/>
                      <a:pt x="184075" y="501138"/>
                      <a:pt x="203649" y="431230"/>
                    </a:cubicBezTo>
                    <a:cubicBezTo>
                      <a:pt x="223223" y="361322"/>
                      <a:pt x="235807" y="267645"/>
                      <a:pt x="220427" y="204727"/>
                    </a:cubicBezTo>
                    <a:cubicBezTo>
                      <a:pt x="205047" y="141810"/>
                      <a:pt x="123953" y="48132"/>
                      <a:pt x="94592" y="20169"/>
                    </a:cubicBezTo>
                    <a:close/>
                  </a:path>
                </a:pathLst>
              </a:custGeom>
              <a:solidFill>
                <a:schemeClr val="accent3">
                  <a:lumMod val="20000"/>
                  <a:lumOff val="8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Freeform 119">
                <a:extLst>
                  <a:ext uri="{FF2B5EF4-FFF2-40B4-BE49-F238E27FC236}">
                    <a16:creationId xmlns:a16="http://schemas.microsoft.com/office/drawing/2014/main" id="{549D946F-4792-491B-93E0-B9EE6AD80EAD}"/>
                  </a:ext>
                </a:extLst>
              </p:cNvPr>
              <p:cNvSpPr/>
              <p:nvPr/>
            </p:nvSpPr>
            <p:spPr>
              <a:xfrm>
                <a:off x="7768296" y="4195173"/>
                <a:ext cx="82936" cy="342632"/>
              </a:xfrm>
              <a:custGeom>
                <a:avLst/>
                <a:gdLst>
                  <a:gd name="connsiteX0" fmla="*/ 94592 w 227293"/>
                  <a:gd name="connsiteY0" fmla="*/ 20169 h 835597"/>
                  <a:gd name="connsiteX1" fmla="*/ 44258 w 227293"/>
                  <a:gd name="connsiteY1" fmla="*/ 36947 h 835597"/>
                  <a:gd name="connsiteX2" fmla="*/ 161704 w 227293"/>
                  <a:gd name="connsiteY2" fmla="*/ 305395 h 835597"/>
                  <a:gd name="connsiteX3" fmla="*/ 2313 w 227293"/>
                  <a:gd name="connsiteY3" fmla="*/ 699678 h 835597"/>
                  <a:gd name="connsiteX4" fmla="*/ 69425 w 227293"/>
                  <a:gd name="connsiteY4" fmla="*/ 833902 h 835597"/>
                  <a:gd name="connsiteX5" fmla="*/ 102981 w 227293"/>
                  <a:gd name="connsiteY5" fmla="*/ 624177 h 835597"/>
                  <a:gd name="connsiteX6" fmla="*/ 203649 w 227293"/>
                  <a:gd name="connsiteY6" fmla="*/ 431230 h 835597"/>
                  <a:gd name="connsiteX7" fmla="*/ 220427 w 227293"/>
                  <a:gd name="connsiteY7" fmla="*/ 204727 h 835597"/>
                  <a:gd name="connsiteX8" fmla="*/ 94592 w 227293"/>
                  <a:gd name="connsiteY8" fmla="*/ 20169 h 835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27293" h="835597">
                    <a:moveTo>
                      <a:pt x="94592" y="20169"/>
                    </a:moveTo>
                    <a:cubicBezTo>
                      <a:pt x="65231" y="-7794"/>
                      <a:pt x="33073" y="-10591"/>
                      <a:pt x="44258" y="36947"/>
                    </a:cubicBezTo>
                    <a:cubicBezTo>
                      <a:pt x="55443" y="84485"/>
                      <a:pt x="168695" y="194940"/>
                      <a:pt x="161704" y="305395"/>
                    </a:cubicBezTo>
                    <a:cubicBezTo>
                      <a:pt x="154713" y="415850"/>
                      <a:pt x="17693" y="611594"/>
                      <a:pt x="2313" y="699678"/>
                    </a:cubicBezTo>
                    <a:cubicBezTo>
                      <a:pt x="-13067" y="787762"/>
                      <a:pt x="52647" y="846486"/>
                      <a:pt x="69425" y="833902"/>
                    </a:cubicBezTo>
                    <a:cubicBezTo>
                      <a:pt x="86203" y="821319"/>
                      <a:pt x="80610" y="691289"/>
                      <a:pt x="102981" y="624177"/>
                    </a:cubicBezTo>
                    <a:cubicBezTo>
                      <a:pt x="125352" y="557065"/>
                      <a:pt x="184075" y="501138"/>
                      <a:pt x="203649" y="431230"/>
                    </a:cubicBezTo>
                    <a:cubicBezTo>
                      <a:pt x="223223" y="361322"/>
                      <a:pt x="235807" y="267645"/>
                      <a:pt x="220427" y="204727"/>
                    </a:cubicBezTo>
                    <a:cubicBezTo>
                      <a:pt x="205047" y="141810"/>
                      <a:pt x="123953" y="48132"/>
                      <a:pt x="94592" y="20169"/>
                    </a:cubicBezTo>
                    <a:close/>
                  </a:path>
                </a:pathLst>
              </a:custGeom>
              <a:solidFill>
                <a:schemeClr val="accent3">
                  <a:lumMod val="20000"/>
                  <a:lumOff val="8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8" name="Oval 87">
                <a:extLst>
                  <a:ext uri="{FF2B5EF4-FFF2-40B4-BE49-F238E27FC236}">
                    <a16:creationId xmlns:a16="http://schemas.microsoft.com/office/drawing/2014/main" id="{DDCB3923-9C06-4351-95E0-25E883047604}"/>
                  </a:ext>
                </a:extLst>
              </p:cNvPr>
              <p:cNvSpPr/>
              <p:nvPr/>
            </p:nvSpPr>
            <p:spPr>
              <a:xfrm>
                <a:off x="7904537" y="4456954"/>
                <a:ext cx="53096" cy="80852"/>
              </a:xfrm>
              <a:prstGeom prst="ellipse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Oval 88">
                <a:extLst>
                  <a:ext uri="{FF2B5EF4-FFF2-40B4-BE49-F238E27FC236}">
                    <a16:creationId xmlns:a16="http://schemas.microsoft.com/office/drawing/2014/main" id="{C33535C3-2478-4507-9218-14BDACCD5BA8}"/>
                  </a:ext>
                </a:extLst>
              </p:cNvPr>
              <p:cNvSpPr/>
              <p:nvPr/>
            </p:nvSpPr>
            <p:spPr>
              <a:xfrm>
                <a:off x="7840783" y="4109582"/>
                <a:ext cx="53096" cy="80852"/>
              </a:xfrm>
              <a:prstGeom prst="ellipse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Oval 89">
                <a:extLst>
                  <a:ext uri="{FF2B5EF4-FFF2-40B4-BE49-F238E27FC236}">
                    <a16:creationId xmlns:a16="http://schemas.microsoft.com/office/drawing/2014/main" id="{F0B41C2F-97E0-4C60-A579-C0EE8E01A5D6}"/>
                  </a:ext>
                </a:extLst>
              </p:cNvPr>
              <p:cNvSpPr/>
              <p:nvPr/>
            </p:nvSpPr>
            <p:spPr>
              <a:xfrm>
                <a:off x="7999143" y="4247179"/>
                <a:ext cx="53096" cy="80852"/>
              </a:xfrm>
              <a:prstGeom prst="ellipse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D17A372C-0A17-4B9A-8C34-636E59F69071}"/>
                  </a:ext>
                </a:extLst>
              </p:cNvPr>
              <p:cNvSpPr txBox="1"/>
              <p:nvPr/>
            </p:nvSpPr>
            <p:spPr>
              <a:xfrm>
                <a:off x="8201166" y="4435653"/>
                <a:ext cx="19620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Non-specific secretion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D40AC31B-9E51-485E-9D9B-814C8F1055BE}"/>
                  </a:ext>
                </a:extLst>
              </p:cNvPr>
              <p:cNvSpPr txBox="1"/>
              <p:nvPr/>
            </p:nvSpPr>
            <p:spPr>
              <a:xfrm>
                <a:off x="7189910" y="4579899"/>
                <a:ext cx="63427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cytosol</a:t>
                </a:r>
              </a:p>
            </p:txBody>
          </p:sp>
        </p:grp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3AD86E69-126D-490D-9E46-3BEA225C7E98}"/>
                </a:ext>
              </a:extLst>
            </p:cNvPr>
            <p:cNvSpPr txBox="1"/>
            <p:nvPr/>
          </p:nvSpPr>
          <p:spPr>
            <a:xfrm>
              <a:off x="7380290" y="5466320"/>
              <a:ext cx="519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94" name="Oval 93">
              <a:extLst>
                <a:ext uri="{FF2B5EF4-FFF2-40B4-BE49-F238E27FC236}">
                  <a16:creationId xmlns:a16="http://schemas.microsoft.com/office/drawing/2014/main" id="{7142B377-6B32-419C-8DBD-129C657C1F7E}"/>
                </a:ext>
              </a:extLst>
            </p:cNvPr>
            <p:cNvSpPr/>
            <p:nvPr/>
          </p:nvSpPr>
          <p:spPr>
            <a:xfrm>
              <a:off x="8655919" y="5575570"/>
              <a:ext cx="47197" cy="47595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FDA2B472-C144-4D48-A304-DE093F5DDDD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51630" y="4990671"/>
              <a:ext cx="2214833" cy="1071981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2CC880A8-26B6-416B-97AC-657EBF444E42}"/>
                </a:ext>
              </a:extLst>
            </p:cNvPr>
            <p:cNvSpPr txBox="1"/>
            <p:nvPr/>
          </p:nvSpPr>
          <p:spPr>
            <a:xfrm>
              <a:off x="5077546" y="5818552"/>
              <a:ext cx="11037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chemeClr val="bg1"/>
                  </a:solidFill>
                </a:rPr>
                <a:t>dSP</a:t>
              </a:r>
              <a:r>
                <a:rPr lang="en-US" sz="1200" b="1" dirty="0">
                  <a:solidFill>
                    <a:schemeClr val="bg1"/>
                  </a:solidFill>
                </a:rPr>
                <a:t>-</a:t>
              </a:r>
              <a:r>
                <a:rPr lang="en-US" sz="1200" b="1" dirty="0" err="1">
                  <a:solidFill>
                    <a:schemeClr val="bg1"/>
                  </a:solidFill>
                </a:rPr>
                <a:t>gLuc</a:t>
              </a:r>
              <a:r>
                <a:rPr lang="en-US" sz="1200" b="1" dirty="0">
                  <a:solidFill>
                    <a:schemeClr val="bg1"/>
                  </a:solidFill>
                </a:rPr>
                <a:t>-RFP</a:t>
              </a:r>
            </a:p>
          </p:txBody>
        </p:sp>
        <p:cxnSp>
          <p:nvCxnSpPr>
            <p:cNvPr id="97" name="Straight Arrow Connector 96">
              <a:extLst>
                <a:ext uri="{FF2B5EF4-FFF2-40B4-BE49-F238E27FC236}">
                  <a16:creationId xmlns:a16="http://schemas.microsoft.com/office/drawing/2014/main" id="{648A8AB0-D694-428B-9000-83B7AF394604}"/>
                </a:ext>
              </a:extLst>
            </p:cNvPr>
            <p:cNvCxnSpPr/>
            <p:nvPr/>
          </p:nvCxnSpPr>
          <p:spPr>
            <a:xfrm>
              <a:off x="5327303" y="5362026"/>
              <a:ext cx="249427" cy="111324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922BFC4-B74D-4BE1-9B92-E10B177E6061}"/>
                </a:ext>
              </a:extLst>
            </p:cNvPr>
            <p:cNvSpPr txBox="1"/>
            <p:nvPr/>
          </p:nvSpPr>
          <p:spPr>
            <a:xfrm>
              <a:off x="5047178" y="5114977"/>
              <a:ext cx="7662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ytosol</a:t>
              </a:r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6D6B446B-F30A-4B37-BAA9-F15198851842}"/>
                </a:ext>
              </a:extLst>
            </p:cNvPr>
            <p:cNvCxnSpPr/>
            <p:nvPr/>
          </p:nvCxnSpPr>
          <p:spPr>
            <a:xfrm>
              <a:off x="5691134" y="5078193"/>
              <a:ext cx="365227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93F0A02D-93D4-43E8-9A0E-22051839D8C6}"/>
                </a:ext>
              </a:extLst>
            </p:cNvPr>
            <p:cNvCxnSpPr/>
            <p:nvPr/>
          </p:nvCxnSpPr>
          <p:spPr>
            <a:xfrm>
              <a:off x="6873554" y="5086163"/>
              <a:ext cx="348105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Oval 100">
              <a:extLst>
                <a:ext uri="{FF2B5EF4-FFF2-40B4-BE49-F238E27FC236}">
                  <a16:creationId xmlns:a16="http://schemas.microsoft.com/office/drawing/2014/main" id="{7641E9B8-C19B-4BB3-86C0-D614C26D04EB}"/>
                </a:ext>
              </a:extLst>
            </p:cNvPr>
            <p:cNvSpPr/>
            <p:nvPr/>
          </p:nvSpPr>
          <p:spPr>
            <a:xfrm>
              <a:off x="8520633" y="5508846"/>
              <a:ext cx="80990" cy="54626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8D1A4651-27CF-400E-A3E5-CC92FD41DF20}"/>
                </a:ext>
              </a:extLst>
            </p:cNvPr>
            <p:cNvSpPr txBox="1"/>
            <p:nvPr/>
          </p:nvSpPr>
          <p:spPr>
            <a:xfrm>
              <a:off x="4689181" y="2552193"/>
              <a:ext cx="65135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 smtClean="0"/>
                <a:t>B</a:t>
              </a:r>
              <a:endParaRPr lang="en-US" sz="2000" b="1" dirty="0"/>
            </a:p>
          </p:txBody>
        </p:sp>
        <p:cxnSp>
          <p:nvCxnSpPr>
            <p:cNvPr id="103" name="Straight Arrow Connector 102">
              <a:extLst>
                <a:ext uri="{FF2B5EF4-FFF2-40B4-BE49-F238E27FC236}">
                  <a16:creationId xmlns:a16="http://schemas.microsoft.com/office/drawing/2014/main" id="{6E7525C5-7308-44ED-AA81-C61CBC2C0E02}"/>
                </a:ext>
              </a:extLst>
            </p:cNvPr>
            <p:cNvCxnSpPr/>
            <p:nvPr/>
          </p:nvCxnSpPr>
          <p:spPr>
            <a:xfrm flipH="1" flipV="1">
              <a:off x="8597773" y="5646140"/>
              <a:ext cx="15986" cy="1530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81499943-40C0-4EE3-8F64-9F4B834651AF}"/>
                </a:ext>
              </a:extLst>
            </p:cNvPr>
            <p:cNvSpPr txBox="1"/>
            <p:nvPr/>
          </p:nvSpPr>
          <p:spPr>
            <a:xfrm>
              <a:off x="5681351" y="2818933"/>
              <a:ext cx="7591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</a:rPr>
                <a:t>10 µm</a:t>
              </a:r>
            </a:p>
          </p:txBody>
        </p:sp>
        <p:sp>
          <p:nvSpPr>
            <p:cNvPr id="105" name="Freeform: Shape 1">
              <a:extLst>
                <a:ext uri="{FF2B5EF4-FFF2-40B4-BE49-F238E27FC236}">
                  <a16:creationId xmlns:a16="http://schemas.microsoft.com/office/drawing/2014/main" id="{70BA8EBC-5346-41F0-80C9-584D1942A242}"/>
                </a:ext>
              </a:extLst>
            </p:cNvPr>
            <p:cNvSpPr/>
            <p:nvPr/>
          </p:nvSpPr>
          <p:spPr>
            <a:xfrm>
              <a:off x="5621399" y="3184884"/>
              <a:ext cx="264956" cy="251883"/>
            </a:xfrm>
            <a:custGeom>
              <a:avLst/>
              <a:gdLst>
                <a:gd name="connsiteX0" fmla="*/ 135740 w 264956"/>
                <a:gd name="connsiteY0" fmla="*/ 1118 h 251883"/>
                <a:gd name="connsiteX1" fmla="*/ 47249 w 264956"/>
                <a:gd name="connsiteY1" fmla="*/ 8492 h 251883"/>
                <a:gd name="connsiteX2" fmla="*/ 3004 w 264956"/>
                <a:gd name="connsiteY2" fmla="*/ 52738 h 251883"/>
                <a:gd name="connsiteX3" fmla="*/ 10378 w 264956"/>
                <a:gd name="connsiteY3" fmla="*/ 133854 h 251883"/>
                <a:gd name="connsiteX4" fmla="*/ 61998 w 264956"/>
                <a:gd name="connsiteY4" fmla="*/ 207596 h 251883"/>
                <a:gd name="connsiteX5" fmla="*/ 143114 w 264956"/>
                <a:gd name="connsiteY5" fmla="*/ 251841 h 251883"/>
                <a:gd name="connsiteX6" fmla="*/ 253727 w 264956"/>
                <a:gd name="connsiteY6" fmla="*/ 200221 h 251883"/>
                <a:gd name="connsiteX7" fmla="*/ 253727 w 264956"/>
                <a:gd name="connsiteY7" fmla="*/ 74860 h 251883"/>
                <a:gd name="connsiteX8" fmla="*/ 187359 w 264956"/>
                <a:gd name="connsiteY8" fmla="*/ 23241 h 251883"/>
                <a:gd name="connsiteX9" fmla="*/ 135740 w 264956"/>
                <a:gd name="connsiteY9" fmla="*/ 1118 h 2518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264956" h="251883">
                  <a:moveTo>
                    <a:pt x="135740" y="1118"/>
                  </a:moveTo>
                  <a:cubicBezTo>
                    <a:pt x="112388" y="-1340"/>
                    <a:pt x="69372" y="-111"/>
                    <a:pt x="47249" y="8492"/>
                  </a:cubicBezTo>
                  <a:cubicBezTo>
                    <a:pt x="25126" y="17095"/>
                    <a:pt x="9149" y="31844"/>
                    <a:pt x="3004" y="52738"/>
                  </a:cubicBezTo>
                  <a:cubicBezTo>
                    <a:pt x="-3141" y="73632"/>
                    <a:pt x="546" y="108044"/>
                    <a:pt x="10378" y="133854"/>
                  </a:cubicBezTo>
                  <a:cubicBezTo>
                    <a:pt x="20210" y="159664"/>
                    <a:pt x="39875" y="187931"/>
                    <a:pt x="61998" y="207596"/>
                  </a:cubicBezTo>
                  <a:cubicBezTo>
                    <a:pt x="84121" y="227261"/>
                    <a:pt x="111159" y="253070"/>
                    <a:pt x="143114" y="251841"/>
                  </a:cubicBezTo>
                  <a:cubicBezTo>
                    <a:pt x="175069" y="250612"/>
                    <a:pt x="235292" y="229718"/>
                    <a:pt x="253727" y="200221"/>
                  </a:cubicBezTo>
                  <a:cubicBezTo>
                    <a:pt x="272163" y="170724"/>
                    <a:pt x="264788" y="104357"/>
                    <a:pt x="253727" y="74860"/>
                  </a:cubicBezTo>
                  <a:cubicBezTo>
                    <a:pt x="242666" y="45363"/>
                    <a:pt x="204565" y="33073"/>
                    <a:pt x="187359" y="23241"/>
                  </a:cubicBezTo>
                  <a:cubicBezTo>
                    <a:pt x="170153" y="13409"/>
                    <a:pt x="159092" y="3576"/>
                    <a:pt x="135740" y="1118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6" name="Freeform: Shape 6">
              <a:extLst>
                <a:ext uri="{FF2B5EF4-FFF2-40B4-BE49-F238E27FC236}">
                  <a16:creationId xmlns:a16="http://schemas.microsoft.com/office/drawing/2014/main" id="{7365A46B-1F1D-4F9E-A464-CC2E6FDC0FDC}"/>
                </a:ext>
              </a:extLst>
            </p:cNvPr>
            <p:cNvSpPr/>
            <p:nvPr/>
          </p:nvSpPr>
          <p:spPr>
            <a:xfrm>
              <a:off x="5822874" y="3371083"/>
              <a:ext cx="303689" cy="220602"/>
            </a:xfrm>
            <a:custGeom>
              <a:avLst/>
              <a:gdLst>
                <a:gd name="connsiteX0" fmla="*/ 236607 w 303689"/>
                <a:gd name="connsiteY0" fmla="*/ 6648 h 220602"/>
                <a:gd name="connsiteX1" fmla="*/ 74374 w 303689"/>
                <a:gd name="connsiteY1" fmla="*/ 21397 h 220602"/>
                <a:gd name="connsiteX2" fmla="*/ 632 w 303689"/>
                <a:gd name="connsiteY2" fmla="*/ 95139 h 220602"/>
                <a:gd name="connsiteX3" fmla="*/ 44878 w 303689"/>
                <a:gd name="connsiteY3" fmla="*/ 191003 h 220602"/>
                <a:gd name="connsiteX4" fmla="*/ 148116 w 303689"/>
                <a:gd name="connsiteY4" fmla="*/ 220500 h 220602"/>
                <a:gd name="connsiteX5" fmla="*/ 243981 w 303689"/>
                <a:gd name="connsiteY5" fmla="*/ 183629 h 220602"/>
                <a:gd name="connsiteX6" fmla="*/ 302974 w 303689"/>
                <a:gd name="connsiteY6" fmla="*/ 117261 h 220602"/>
                <a:gd name="connsiteX7" fmla="*/ 236607 w 303689"/>
                <a:gd name="connsiteY7" fmla="*/ 6648 h 2206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03689" h="220602">
                  <a:moveTo>
                    <a:pt x="236607" y="6648"/>
                  </a:moveTo>
                  <a:cubicBezTo>
                    <a:pt x="198507" y="-9329"/>
                    <a:pt x="113703" y="6649"/>
                    <a:pt x="74374" y="21397"/>
                  </a:cubicBezTo>
                  <a:cubicBezTo>
                    <a:pt x="35045" y="36146"/>
                    <a:pt x="5548" y="66871"/>
                    <a:pt x="632" y="95139"/>
                  </a:cubicBezTo>
                  <a:cubicBezTo>
                    <a:pt x="-4284" y="123407"/>
                    <a:pt x="20297" y="170110"/>
                    <a:pt x="44878" y="191003"/>
                  </a:cubicBezTo>
                  <a:cubicBezTo>
                    <a:pt x="69459" y="211896"/>
                    <a:pt x="114932" y="221729"/>
                    <a:pt x="148116" y="220500"/>
                  </a:cubicBezTo>
                  <a:cubicBezTo>
                    <a:pt x="181300" y="219271"/>
                    <a:pt x="218171" y="200835"/>
                    <a:pt x="243981" y="183629"/>
                  </a:cubicBezTo>
                  <a:cubicBezTo>
                    <a:pt x="269791" y="166423"/>
                    <a:pt x="296829" y="143071"/>
                    <a:pt x="302974" y="117261"/>
                  </a:cubicBezTo>
                  <a:cubicBezTo>
                    <a:pt x="309119" y="91451"/>
                    <a:pt x="274707" y="22625"/>
                    <a:pt x="236607" y="6648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Freeform: Shape 289">
              <a:extLst>
                <a:ext uri="{FF2B5EF4-FFF2-40B4-BE49-F238E27FC236}">
                  <a16:creationId xmlns:a16="http://schemas.microsoft.com/office/drawing/2014/main" id="{64A2444A-2B2B-40E0-9CE6-BEB6C0BAC86C}"/>
                </a:ext>
              </a:extLst>
            </p:cNvPr>
            <p:cNvSpPr/>
            <p:nvPr/>
          </p:nvSpPr>
          <p:spPr>
            <a:xfrm>
              <a:off x="6723942" y="3207347"/>
              <a:ext cx="264956" cy="251883"/>
            </a:xfrm>
            <a:custGeom>
              <a:avLst/>
              <a:gdLst>
                <a:gd name="connsiteX0" fmla="*/ 135740 w 264956"/>
                <a:gd name="connsiteY0" fmla="*/ 1118 h 251883"/>
                <a:gd name="connsiteX1" fmla="*/ 47249 w 264956"/>
                <a:gd name="connsiteY1" fmla="*/ 8492 h 251883"/>
                <a:gd name="connsiteX2" fmla="*/ 3004 w 264956"/>
                <a:gd name="connsiteY2" fmla="*/ 52738 h 251883"/>
                <a:gd name="connsiteX3" fmla="*/ 10378 w 264956"/>
                <a:gd name="connsiteY3" fmla="*/ 133854 h 251883"/>
                <a:gd name="connsiteX4" fmla="*/ 61998 w 264956"/>
                <a:gd name="connsiteY4" fmla="*/ 207596 h 251883"/>
                <a:gd name="connsiteX5" fmla="*/ 143114 w 264956"/>
                <a:gd name="connsiteY5" fmla="*/ 251841 h 251883"/>
                <a:gd name="connsiteX6" fmla="*/ 253727 w 264956"/>
                <a:gd name="connsiteY6" fmla="*/ 200221 h 251883"/>
                <a:gd name="connsiteX7" fmla="*/ 253727 w 264956"/>
                <a:gd name="connsiteY7" fmla="*/ 74860 h 251883"/>
                <a:gd name="connsiteX8" fmla="*/ 187359 w 264956"/>
                <a:gd name="connsiteY8" fmla="*/ 23241 h 251883"/>
                <a:gd name="connsiteX9" fmla="*/ 135740 w 264956"/>
                <a:gd name="connsiteY9" fmla="*/ 1118 h 2518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264956" h="251883">
                  <a:moveTo>
                    <a:pt x="135740" y="1118"/>
                  </a:moveTo>
                  <a:cubicBezTo>
                    <a:pt x="112388" y="-1340"/>
                    <a:pt x="69372" y="-111"/>
                    <a:pt x="47249" y="8492"/>
                  </a:cubicBezTo>
                  <a:cubicBezTo>
                    <a:pt x="25126" y="17095"/>
                    <a:pt x="9149" y="31844"/>
                    <a:pt x="3004" y="52738"/>
                  </a:cubicBezTo>
                  <a:cubicBezTo>
                    <a:pt x="-3141" y="73632"/>
                    <a:pt x="546" y="108044"/>
                    <a:pt x="10378" y="133854"/>
                  </a:cubicBezTo>
                  <a:cubicBezTo>
                    <a:pt x="20210" y="159664"/>
                    <a:pt x="39875" y="187931"/>
                    <a:pt x="61998" y="207596"/>
                  </a:cubicBezTo>
                  <a:cubicBezTo>
                    <a:pt x="84121" y="227261"/>
                    <a:pt x="111159" y="253070"/>
                    <a:pt x="143114" y="251841"/>
                  </a:cubicBezTo>
                  <a:cubicBezTo>
                    <a:pt x="175069" y="250612"/>
                    <a:pt x="235292" y="229718"/>
                    <a:pt x="253727" y="200221"/>
                  </a:cubicBezTo>
                  <a:cubicBezTo>
                    <a:pt x="272163" y="170724"/>
                    <a:pt x="264788" y="104357"/>
                    <a:pt x="253727" y="74860"/>
                  </a:cubicBezTo>
                  <a:cubicBezTo>
                    <a:pt x="242666" y="45363"/>
                    <a:pt x="204565" y="33073"/>
                    <a:pt x="187359" y="23241"/>
                  </a:cubicBezTo>
                  <a:cubicBezTo>
                    <a:pt x="170153" y="13409"/>
                    <a:pt x="159092" y="3576"/>
                    <a:pt x="135740" y="1118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8" name="Freeform: Shape 290">
              <a:extLst>
                <a:ext uri="{FF2B5EF4-FFF2-40B4-BE49-F238E27FC236}">
                  <a16:creationId xmlns:a16="http://schemas.microsoft.com/office/drawing/2014/main" id="{E4E1FBB4-002B-4A51-A4A1-67098B10E13D}"/>
                </a:ext>
              </a:extLst>
            </p:cNvPr>
            <p:cNvSpPr/>
            <p:nvPr/>
          </p:nvSpPr>
          <p:spPr>
            <a:xfrm>
              <a:off x="6925417" y="3393546"/>
              <a:ext cx="303689" cy="220602"/>
            </a:xfrm>
            <a:custGeom>
              <a:avLst/>
              <a:gdLst>
                <a:gd name="connsiteX0" fmla="*/ 236607 w 303689"/>
                <a:gd name="connsiteY0" fmla="*/ 6648 h 220602"/>
                <a:gd name="connsiteX1" fmla="*/ 74374 w 303689"/>
                <a:gd name="connsiteY1" fmla="*/ 21397 h 220602"/>
                <a:gd name="connsiteX2" fmla="*/ 632 w 303689"/>
                <a:gd name="connsiteY2" fmla="*/ 95139 h 220602"/>
                <a:gd name="connsiteX3" fmla="*/ 44878 w 303689"/>
                <a:gd name="connsiteY3" fmla="*/ 191003 h 220602"/>
                <a:gd name="connsiteX4" fmla="*/ 148116 w 303689"/>
                <a:gd name="connsiteY4" fmla="*/ 220500 h 220602"/>
                <a:gd name="connsiteX5" fmla="*/ 243981 w 303689"/>
                <a:gd name="connsiteY5" fmla="*/ 183629 h 220602"/>
                <a:gd name="connsiteX6" fmla="*/ 302974 w 303689"/>
                <a:gd name="connsiteY6" fmla="*/ 117261 h 220602"/>
                <a:gd name="connsiteX7" fmla="*/ 236607 w 303689"/>
                <a:gd name="connsiteY7" fmla="*/ 6648 h 2206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03689" h="220602">
                  <a:moveTo>
                    <a:pt x="236607" y="6648"/>
                  </a:moveTo>
                  <a:cubicBezTo>
                    <a:pt x="198507" y="-9329"/>
                    <a:pt x="113703" y="6649"/>
                    <a:pt x="74374" y="21397"/>
                  </a:cubicBezTo>
                  <a:cubicBezTo>
                    <a:pt x="35045" y="36146"/>
                    <a:pt x="5548" y="66871"/>
                    <a:pt x="632" y="95139"/>
                  </a:cubicBezTo>
                  <a:cubicBezTo>
                    <a:pt x="-4284" y="123407"/>
                    <a:pt x="20297" y="170110"/>
                    <a:pt x="44878" y="191003"/>
                  </a:cubicBezTo>
                  <a:cubicBezTo>
                    <a:pt x="69459" y="211896"/>
                    <a:pt x="114932" y="221729"/>
                    <a:pt x="148116" y="220500"/>
                  </a:cubicBezTo>
                  <a:cubicBezTo>
                    <a:pt x="181300" y="219271"/>
                    <a:pt x="218171" y="200835"/>
                    <a:pt x="243981" y="183629"/>
                  </a:cubicBezTo>
                  <a:cubicBezTo>
                    <a:pt x="269791" y="166423"/>
                    <a:pt x="296829" y="143071"/>
                    <a:pt x="302974" y="117261"/>
                  </a:cubicBezTo>
                  <a:cubicBezTo>
                    <a:pt x="309119" y="91451"/>
                    <a:pt x="274707" y="22625"/>
                    <a:pt x="236607" y="6648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Freeform: Shape 7">
              <a:extLst>
                <a:ext uri="{FF2B5EF4-FFF2-40B4-BE49-F238E27FC236}">
                  <a16:creationId xmlns:a16="http://schemas.microsoft.com/office/drawing/2014/main" id="{8F83429A-EB77-46E7-8DD3-BE77762B588A}"/>
                </a:ext>
              </a:extLst>
            </p:cNvPr>
            <p:cNvSpPr/>
            <p:nvPr/>
          </p:nvSpPr>
          <p:spPr>
            <a:xfrm>
              <a:off x="5542989" y="4327358"/>
              <a:ext cx="258768" cy="210682"/>
            </a:xfrm>
            <a:custGeom>
              <a:avLst/>
              <a:gdLst>
                <a:gd name="connsiteX0" fmla="*/ 140408 w 258768"/>
                <a:gd name="connsiteY0" fmla="*/ 1644 h 210682"/>
                <a:gd name="connsiteX1" fmla="*/ 22421 w 258768"/>
                <a:gd name="connsiteY1" fmla="*/ 60638 h 210682"/>
                <a:gd name="connsiteX2" fmla="*/ 7672 w 258768"/>
                <a:gd name="connsiteY2" fmla="*/ 156502 h 210682"/>
                <a:gd name="connsiteX3" fmla="*/ 110911 w 258768"/>
                <a:gd name="connsiteY3" fmla="*/ 208122 h 210682"/>
                <a:gd name="connsiteX4" fmla="*/ 206775 w 258768"/>
                <a:gd name="connsiteY4" fmla="*/ 193373 h 210682"/>
                <a:gd name="connsiteX5" fmla="*/ 228898 w 258768"/>
                <a:gd name="connsiteY5" fmla="*/ 112257 h 210682"/>
                <a:gd name="connsiteX6" fmla="*/ 258395 w 258768"/>
                <a:gd name="connsiteY6" fmla="*/ 31141 h 210682"/>
                <a:gd name="connsiteX7" fmla="*/ 206775 w 258768"/>
                <a:gd name="connsiteY7" fmla="*/ 16393 h 210682"/>
                <a:gd name="connsiteX8" fmla="*/ 140408 w 258768"/>
                <a:gd name="connsiteY8" fmla="*/ 1644 h 2106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58768" h="210682">
                  <a:moveTo>
                    <a:pt x="140408" y="1644"/>
                  </a:moveTo>
                  <a:cubicBezTo>
                    <a:pt x="109682" y="9018"/>
                    <a:pt x="44544" y="34828"/>
                    <a:pt x="22421" y="60638"/>
                  </a:cubicBezTo>
                  <a:cubicBezTo>
                    <a:pt x="298" y="86448"/>
                    <a:pt x="-7076" y="131921"/>
                    <a:pt x="7672" y="156502"/>
                  </a:cubicBezTo>
                  <a:cubicBezTo>
                    <a:pt x="22420" y="181083"/>
                    <a:pt x="77727" y="201977"/>
                    <a:pt x="110911" y="208122"/>
                  </a:cubicBezTo>
                  <a:cubicBezTo>
                    <a:pt x="144095" y="214267"/>
                    <a:pt x="187111" y="209350"/>
                    <a:pt x="206775" y="193373"/>
                  </a:cubicBezTo>
                  <a:cubicBezTo>
                    <a:pt x="226439" y="177396"/>
                    <a:pt x="220295" y="139296"/>
                    <a:pt x="228898" y="112257"/>
                  </a:cubicBezTo>
                  <a:cubicBezTo>
                    <a:pt x="237501" y="85218"/>
                    <a:pt x="262082" y="47118"/>
                    <a:pt x="258395" y="31141"/>
                  </a:cubicBezTo>
                  <a:cubicBezTo>
                    <a:pt x="254708" y="15164"/>
                    <a:pt x="227668" y="18851"/>
                    <a:pt x="206775" y="16393"/>
                  </a:cubicBezTo>
                  <a:cubicBezTo>
                    <a:pt x="185882" y="13935"/>
                    <a:pt x="171134" y="-5730"/>
                    <a:pt x="140408" y="1644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Freeform: Shape 8">
              <a:extLst>
                <a:ext uri="{FF2B5EF4-FFF2-40B4-BE49-F238E27FC236}">
                  <a16:creationId xmlns:a16="http://schemas.microsoft.com/office/drawing/2014/main" id="{B578AB10-FC60-4CB8-A19F-B87A75A61A75}"/>
                </a:ext>
              </a:extLst>
            </p:cNvPr>
            <p:cNvSpPr/>
            <p:nvPr/>
          </p:nvSpPr>
          <p:spPr>
            <a:xfrm>
              <a:off x="5358559" y="5527726"/>
              <a:ext cx="346985" cy="390975"/>
            </a:xfrm>
            <a:custGeom>
              <a:avLst/>
              <a:gdLst>
                <a:gd name="connsiteX0" fmla="*/ 199476 w 346985"/>
                <a:gd name="connsiteY0" fmla="*/ 10644 h 390975"/>
                <a:gd name="connsiteX1" fmla="*/ 287967 w 346985"/>
                <a:gd name="connsiteY1" fmla="*/ 10644 h 390975"/>
                <a:gd name="connsiteX2" fmla="*/ 295341 w 346985"/>
                <a:gd name="connsiteY2" fmla="*/ 106508 h 390975"/>
                <a:gd name="connsiteX3" fmla="*/ 346960 w 346985"/>
                <a:gd name="connsiteY3" fmla="*/ 121257 h 390975"/>
                <a:gd name="connsiteX4" fmla="*/ 287967 w 346985"/>
                <a:gd name="connsiteY4" fmla="*/ 268741 h 390975"/>
                <a:gd name="connsiteX5" fmla="*/ 51993 w 346985"/>
                <a:gd name="connsiteY5" fmla="*/ 386728 h 390975"/>
                <a:gd name="connsiteX6" fmla="*/ 29870 w 346985"/>
                <a:gd name="connsiteY6" fmla="*/ 357231 h 390975"/>
                <a:gd name="connsiteX7" fmla="*/ 373 w 346985"/>
                <a:gd name="connsiteY7" fmla="*/ 283489 h 390975"/>
                <a:gd name="connsiteX8" fmla="*/ 51993 w 346985"/>
                <a:gd name="connsiteY8" fmla="*/ 202373 h 390975"/>
                <a:gd name="connsiteX9" fmla="*/ 103612 w 346985"/>
                <a:gd name="connsiteY9" fmla="*/ 158128 h 390975"/>
                <a:gd name="connsiteX10" fmla="*/ 162605 w 346985"/>
                <a:gd name="connsiteY10" fmla="*/ 136005 h 390975"/>
                <a:gd name="connsiteX11" fmla="*/ 133109 w 346985"/>
                <a:gd name="connsiteY11" fmla="*/ 84386 h 390975"/>
                <a:gd name="connsiteX12" fmla="*/ 199476 w 346985"/>
                <a:gd name="connsiteY12" fmla="*/ 10644 h 3909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346985" h="390975">
                  <a:moveTo>
                    <a:pt x="199476" y="10644"/>
                  </a:moveTo>
                  <a:cubicBezTo>
                    <a:pt x="225286" y="-1646"/>
                    <a:pt x="271990" y="-5333"/>
                    <a:pt x="287967" y="10644"/>
                  </a:cubicBezTo>
                  <a:cubicBezTo>
                    <a:pt x="303944" y="26621"/>
                    <a:pt x="285509" y="88073"/>
                    <a:pt x="295341" y="106508"/>
                  </a:cubicBezTo>
                  <a:cubicBezTo>
                    <a:pt x="305173" y="124943"/>
                    <a:pt x="348189" y="94218"/>
                    <a:pt x="346960" y="121257"/>
                  </a:cubicBezTo>
                  <a:cubicBezTo>
                    <a:pt x="345731" y="148296"/>
                    <a:pt x="337128" y="224496"/>
                    <a:pt x="287967" y="268741"/>
                  </a:cubicBezTo>
                  <a:cubicBezTo>
                    <a:pt x="238806" y="312986"/>
                    <a:pt x="51993" y="386728"/>
                    <a:pt x="51993" y="386728"/>
                  </a:cubicBezTo>
                  <a:cubicBezTo>
                    <a:pt x="8977" y="401476"/>
                    <a:pt x="38473" y="374437"/>
                    <a:pt x="29870" y="357231"/>
                  </a:cubicBezTo>
                  <a:cubicBezTo>
                    <a:pt x="21267" y="340025"/>
                    <a:pt x="-3314" y="309299"/>
                    <a:pt x="373" y="283489"/>
                  </a:cubicBezTo>
                  <a:cubicBezTo>
                    <a:pt x="4060" y="257679"/>
                    <a:pt x="34787" y="223266"/>
                    <a:pt x="51993" y="202373"/>
                  </a:cubicBezTo>
                  <a:cubicBezTo>
                    <a:pt x="69199" y="181480"/>
                    <a:pt x="85177" y="169189"/>
                    <a:pt x="103612" y="158128"/>
                  </a:cubicBezTo>
                  <a:cubicBezTo>
                    <a:pt x="122047" y="147067"/>
                    <a:pt x="157689" y="148295"/>
                    <a:pt x="162605" y="136005"/>
                  </a:cubicBezTo>
                  <a:cubicBezTo>
                    <a:pt x="167521" y="123715"/>
                    <a:pt x="130651" y="104050"/>
                    <a:pt x="133109" y="84386"/>
                  </a:cubicBezTo>
                  <a:cubicBezTo>
                    <a:pt x="135567" y="64722"/>
                    <a:pt x="173666" y="22934"/>
                    <a:pt x="199476" y="10644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Freeform: Shape 291">
              <a:extLst>
                <a:ext uri="{FF2B5EF4-FFF2-40B4-BE49-F238E27FC236}">
                  <a16:creationId xmlns:a16="http://schemas.microsoft.com/office/drawing/2014/main" id="{2FD2EF10-E59A-4BA2-A516-15C371135C44}"/>
                </a:ext>
              </a:extLst>
            </p:cNvPr>
            <p:cNvSpPr/>
            <p:nvPr/>
          </p:nvSpPr>
          <p:spPr>
            <a:xfrm>
              <a:off x="6624632" y="4349805"/>
              <a:ext cx="258768" cy="210682"/>
            </a:xfrm>
            <a:custGeom>
              <a:avLst/>
              <a:gdLst>
                <a:gd name="connsiteX0" fmla="*/ 140408 w 258768"/>
                <a:gd name="connsiteY0" fmla="*/ 1644 h 210682"/>
                <a:gd name="connsiteX1" fmla="*/ 22421 w 258768"/>
                <a:gd name="connsiteY1" fmla="*/ 60638 h 210682"/>
                <a:gd name="connsiteX2" fmla="*/ 7672 w 258768"/>
                <a:gd name="connsiteY2" fmla="*/ 156502 h 210682"/>
                <a:gd name="connsiteX3" fmla="*/ 110911 w 258768"/>
                <a:gd name="connsiteY3" fmla="*/ 208122 h 210682"/>
                <a:gd name="connsiteX4" fmla="*/ 206775 w 258768"/>
                <a:gd name="connsiteY4" fmla="*/ 193373 h 210682"/>
                <a:gd name="connsiteX5" fmla="*/ 228898 w 258768"/>
                <a:gd name="connsiteY5" fmla="*/ 112257 h 210682"/>
                <a:gd name="connsiteX6" fmla="*/ 258395 w 258768"/>
                <a:gd name="connsiteY6" fmla="*/ 31141 h 210682"/>
                <a:gd name="connsiteX7" fmla="*/ 206775 w 258768"/>
                <a:gd name="connsiteY7" fmla="*/ 16393 h 210682"/>
                <a:gd name="connsiteX8" fmla="*/ 140408 w 258768"/>
                <a:gd name="connsiteY8" fmla="*/ 1644 h 2106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58768" h="210682">
                  <a:moveTo>
                    <a:pt x="140408" y="1644"/>
                  </a:moveTo>
                  <a:cubicBezTo>
                    <a:pt x="109682" y="9018"/>
                    <a:pt x="44544" y="34828"/>
                    <a:pt x="22421" y="60638"/>
                  </a:cubicBezTo>
                  <a:cubicBezTo>
                    <a:pt x="298" y="86448"/>
                    <a:pt x="-7076" y="131921"/>
                    <a:pt x="7672" y="156502"/>
                  </a:cubicBezTo>
                  <a:cubicBezTo>
                    <a:pt x="22420" y="181083"/>
                    <a:pt x="77727" y="201977"/>
                    <a:pt x="110911" y="208122"/>
                  </a:cubicBezTo>
                  <a:cubicBezTo>
                    <a:pt x="144095" y="214267"/>
                    <a:pt x="187111" y="209350"/>
                    <a:pt x="206775" y="193373"/>
                  </a:cubicBezTo>
                  <a:cubicBezTo>
                    <a:pt x="226439" y="177396"/>
                    <a:pt x="220295" y="139296"/>
                    <a:pt x="228898" y="112257"/>
                  </a:cubicBezTo>
                  <a:cubicBezTo>
                    <a:pt x="237501" y="85218"/>
                    <a:pt x="262082" y="47118"/>
                    <a:pt x="258395" y="31141"/>
                  </a:cubicBezTo>
                  <a:cubicBezTo>
                    <a:pt x="254708" y="15164"/>
                    <a:pt x="227668" y="18851"/>
                    <a:pt x="206775" y="16393"/>
                  </a:cubicBezTo>
                  <a:cubicBezTo>
                    <a:pt x="185882" y="13935"/>
                    <a:pt x="171134" y="-5730"/>
                    <a:pt x="140408" y="1644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Freeform: Shape 292">
              <a:extLst>
                <a:ext uri="{FF2B5EF4-FFF2-40B4-BE49-F238E27FC236}">
                  <a16:creationId xmlns:a16="http://schemas.microsoft.com/office/drawing/2014/main" id="{B5B2FDAE-631A-448E-859F-062FB779D5AA}"/>
                </a:ext>
              </a:extLst>
            </p:cNvPr>
            <p:cNvSpPr/>
            <p:nvPr/>
          </p:nvSpPr>
          <p:spPr>
            <a:xfrm>
              <a:off x="6447956" y="5554820"/>
              <a:ext cx="346985" cy="390975"/>
            </a:xfrm>
            <a:custGeom>
              <a:avLst/>
              <a:gdLst>
                <a:gd name="connsiteX0" fmla="*/ 199476 w 346985"/>
                <a:gd name="connsiteY0" fmla="*/ 10644 h 390975"/>
                <a:gd name="connsiteX1" fmla="*/ 287967 w 346985"/>
                <a:gd name="connsiteY1" fmla="*/ 10644 h 390975"/>
                <a:gd name="connsiteX2" fmla="*/ 295341 w 346985"/>
                <a:gd name="connsiteY2" fmla="*/ 106508 h 390975"/>
                <a:gd name="connsiteX3" fmla="*/ 346960 w 346985"/>
                <a:gd name="connsiteY3" fmla="*/ 121257 h 390975"/>
                <a:gd name="connsiteX4" fmla="*/ 287967 w 346985"/>
                <a:gd name="connsiteY4" fmla="*/ 268741 h 390975"/>
                <a:gd name="connsiteX5" fmla="*/ 51993 w 346985"/>
                <a:gd name="connsiteY5" fmla="*/ 386728 h 390975"/>
                <a:gd name="connsiteX6" fmla="*/ 29870 w 346985"/>
                <a:gd name="connsiteY6" fmla="*/ 357231 h 390975"/>
                <a:gd name="connsiteX7" fmla="*/ 373 w 346985"/>
                <a:gd name="connsiteY7" fmla="*/ 283489 h 390975"/>
                <a:gd name="connsiteX8" fmla="*/ 51993 w 346985"/>
                <a:gd name="connsiteY8" fmla="*/ 202373 h 390975"/>
                <a:gd name="connsiteX9" fmla="*/ 103612 w 346985"/>
                <a:gd name="connsiteY9" fmla="*/ 158128 h 390975"/>
                <a:gd name="connsiteX10" fmla="*/ 162605 w 346985"/>
                <a:gd name="connsiteY10" fmla="*/ 136005 h 390975"/>
                <a:gd name="connsiteX11" fmla="*/ 133109 w 346985"/>
                <a:gd name="connsiteY11" fmla="*/ 84386 h 390975"/>
                <a:gd name="connsiteX12" fmla="*/ 199476 w 346985"/>
                <a:gd name="connsiteY12" fmla="*/ 10644 h 3909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346985" h="390975">
                  <a:moveTo>
                    <a:pt x="199476" y="10644"/>
                  </a:moveTo>
                  <a:cubicBezTo>
                    <a:pt x="225286" y="-1646"/>
                    <a:pt x="271990" y="-5333"/>
                    <a:pt x="287967" y="10644"/>
                  </a:cubicBezTo>
                  <a:cubicBezTo>
                    <a:pt x="303944" y="26621"/>
                    <a:pt x="285509" y="88073"/>
                    <a:pt x="295341" y="106508"/>
                  </a:cubicBezTo>
                  <a:cubicBezTo>
                    <a:pt x="305173" y="124943"/>
                    <a:pt x="348189" y="94218"/>
                    <a:pt x="346960" y="121257"/>
                  </a:cubicBezTo>
                  <a:cubicBezTo>
                    <a:pt x="345731" y="148296"/>
                    <a:pt x="337128" y="224496"/>
                    <a:pt x="287967" y="268741"/>
                  </a:cubicBezTo>
                  <a:cubicBezTo>
                    <a:pt x="238806" y="312986"/>
                    <a:pt x="51993" y="386728"/>
                    <a:pt x="51993" y="386728"/>
                  </a:cubicBezTo>
                  <a:cubicBezTo>
                    <a:pt x="8977" y="401476"/>
                    <a:pt x="38473" y="374437"/>
                    <a:pt x="29870" y="357231"/>
                  </a:cubicBezTo>
                  <a:cubicBezTo>
                    <a:pt x="21267" y="340025"/>
                    <a:pt x="-3314" y="309299"/>
                    <a:pt x="373" y="283489"/>
                  </a:cubicBezTo>
                  <a:cubicBezTo>
                    <a:pt x="4060" y="257679"/>
                    <a:pt x="34787" y="223266"/>
                    <a:pt x="51993" y="202373"/>
                  </a:cubicBezTo>
                  <a:cubicBezTo>
                    <a:pt x="69199" y="181480"/>
                    <a:pt x="85177" y="169189"/>
                    <a:pt x="103612" y="158128"/>
                  </a:cubicBezTo>
                  <a:cubicBezTo>
                    <a:pt x="122047" y="147067"/>
                    <a:pt x="157689" y="148295"/>
                    <a:pt x="162605" y="136005"/>
                  </a:cubicBezTo>
                  <a:cubicBezTo>
                    <a:pt x="167521" y="123715"/>
                    <a:pt x="130651" y="104050"/>
                    <a:pt x="133109" y="84386"/>
                  </a:cubicBezTo>
                  <a:cubicBezTo>
                    <a:pt x="135567" y="64722"/>
                    <a:pt x="173666" y="22934"/>
                    <a:pt x="199476" y="10644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Freeform: Shape 295">
              <a:extLst>
                <a:ext uri="{FF2B5EF4-FFF2-40B4-BE49-F238E27FC236}">
                  <a16:creationId xmlns:a16="http://schemas.microsoft.com/office/drawing/2014/main" id="{9BA02113-E2E9-4EBD-A0ED-9D4CAD955B4E}"/>
                </a:ext>
              </a:extLst>
            </p:cNvPr>
            <p:cNvSpPr/>
            <p:nvPr/>
          </p:nvSpPr>
          <p:spPr>
            <a:xfrm>
              <a:off x="7559342" y="5573639"/>
              <a:ext cx="346985" cy="390975"/>
            </a:xfrm>
            <a:custGeom>
              <a:avLst/>
              <a:gdLst>
                <a:gd name="connsiteX0" fmla="*/ 199476 w 346985"/>
                <a:gd name="connsiteY0" fmla="*/ 10644 h 390975"/>
                <a:gd name="connsiteX1" fmla="*/ 287967 w 346985"/>
                <a:gd name="connsiteY1" fmla="*/ 10644 h 390975"/>
                <a:gd name="connsiteX2" fmla="*/ 295341 w 346985"/>
                <a:gd name="connsiteY2" fmla="*/ 106508 h 390975"/>
                <a:gd name="connsiteX3" fmla="*/ 346960 w 346985"/>
                <a:gd name="connsiteY3" fmla="*/ 121257 h 390975"/>
                <a:gd name="connsiteX4" fmla="*/ 287967 w 346985"/>
                <a:gd name="connsiteY4" fmla="*/ 268741 h 390975"/>
                <a:gd name="connsiteX5" fmla="*/ 51993 w 346985"/>
                <a:gd name="connsiteY5" fmla="*/ 386728 h 390975"/>
                <a:gd name="connsiteX6" fmla="*/ 29870 w 346985"/>
                <a:gd name="connsiteY6" fmla="*/ 357231 h 390975"/>
                <a:gd name="connsiteX7" fmla="*/ 373 w 346985"/>
                <a:gd name="connsiteY7" fmla="*/ 283489 h 390975"/>
                <a:gd name="connsiteX8" fmla="*/ 51993 w 346985"/>
                <a:gd name="connsiteY8" fmla="*/ 202373 h 390975"/>
                <a:gd name="connsiteX9" fmla="*/ 103612 w 346985"/>
                <a:gd name="connsiteY9" fmla="*/ 158128 h 390975"/>
                <a:gd name="connsiteX10" fmla="*/ 162605 w 346985"/>
                <a:gd name="connsiteY10" fmla="*/ 136005 h 390975"/>
                <a:gd name="connsiteX11" fmla="*/ 133109 w 346985"/>
                <a:gd name="connsiteY11" fmla="*/ 84386 h 390975"/>
                <a:gd name="connsiteX12" fmla="*/ 199476 w 346985"/>
                <a:gd name="connsiteY12" fmla="*/ 10644 h 3909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346985" h="390975">
                  <a:moveTo>
                    <a:pt x="199476" y="10644"/>
                  </a:moveTo>
                  <a:cubicBezTo>
                    <a:pt x="225286" y="-1646"/>
                    <a:pt x="271990" y="-5333"/>
                    <a:pt x="287967" y="10644"/>
                  </a:cubicBezTo>
                  <a:cubicBezTo>
                    <a:pt x="303944" y="26621"/>
                    <a:pt x="285509" y="88073"/>
                    <a:pt x="295341" y="106508"/>
                  </a:cubicBezTo>
                  <a:cubicBezTo>
                    <a:pt x="305173" y="124943"/>
                    <a:pt x="348189" y="94218"/>
                    <a:pt x="346960" y="121257"/>
                  </a:cubicBezTo>
                  <a:cubicBezTo>
                    <a:pt x="345731" y="148296"/>
                    <a:pt x="337128" y="224496"/>
                    <a:pt x="287967" y="268741"/>
                  </a:cubicBezTo>
                  <a:cubicBezTo>
                    <a:pt x="238806" y="312986"/>
                    <a:pt x="51993" y="386728"/>
                    <a:pt x="51993" y="386728"/>
                  </a:cubicBezTo>
                  <a:cubicBezTo>
                    <a:pt x="8977" y="401476"/>
                    <a:pt x="38473" y="374437"/>
                    <a:pt x="29870" y="357231"/>
                  </a:cubicBezTo>
                  <a:cubicBezTo>
                    <a:pt x="21267" y="340025"/>
                    <a:pt x="-3314" y="309299"/>
                    <a:pt x="373" y="283489"/>
                  </a:cubicBezTo>
                  <a:cubicBezTo>
                    <a:pt x="4060" y="257679"/>
                    <a:pt x="34787" y="223266"/>
                    <a:pt x="51993" y="202373"/>
                  </a:cubicBezTo>
                  <a:cubicBezTo>
                    <a:pt x="69199" y="181480"/>
                    <a:pt x="85177" y="169189"/>
                    <a:pt x="103612" y="158128"/>
                  </a:cubicBezTo>
                  <a:cubicBezTo>
                    <a:pt x="122047" y="147067"/>
                    <a:pt x="157689" y="148295"/>
                    <a:pt x="162605" y="136005"/>
                  </a:cubicBezTo>
                  <a:cubicBezTo>
                    <a:pt x="167521" y="123715"/>
                    <a:pt x="130651" y="104050"/>
                    <a:pt x="133109" y="84386"/>
                  </a:cubicBezTo>
                  <a:cubicBezTo>
                    <a:pt x="135567" y="64722"/>
                    <a:pt x="173666" y="22934"/>
                    <a:pt x="199476" y="10644"/>
                  </a:cubicBezTo>
                  <a:close/>
                </a:path>
              </a:pathLst>
            </a:custGeom>
            <a:noFill/>
            <a:ln w="127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BBC203B-F53E-4BAF-AE97-B91F76CC27E9}"/>
                </a:ext>
              </a:extLst>
            </p:cNvPr>
            <p:cNvSpPr txBox="1"/>
            <p:nvPr/>
          </p:nvSpPr>
          <p:spPr>
            <a:xfrm>
              <a:off x="5398115" y="5591384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AE09891D-5242-43E1-A35E-3F745C94D627}"/>
                </a:ext>
              </a:extLst>
            </p:cNvPr>
            <p:cNvSpPr txBox="1"/>
            <p:nvPr/>
          </p:nvSpPr>
          <p:spPr>
            <a:xfrm>
              <a:off x="5481340" y="4283050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6C4F248F-8094-4AE0-A91C-3F1755B637BE}"/>
                </a:ext>
              </a:extLst>
            </p:cNvPr>
            <p:cNvSpPr txBox="1"/>
            <p:nvPr/>
          </p:nvSpPr>
          <p:spPr>
            <a:xfrm>
              <a:off x="5564467" y="3166241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E06D0BC3-99D4-42F1-88EF-A882CA76671F}"/>
                </a:ext>
              </a:extLst>
            </p:cNvPr>
            <p:cNvSpPr txBox="1"/>
            <p:nvPr/>
          </p:nvSpPr>
          <p:spPr>
            <a:xfrm>
              <a:off x="6486388" y="5616906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726AAD9D-EEE8-4CAB-A2B4-D82D2EE70090}"/>
                </a:ext>
              </a:extLst>
            </p:cNvPr>
            <p:cNvSpPr txBox="1"/>
            <p:nvPr/>
          </p:nvSpPr>
          <p:spPr>
            <a:xfrm>
              <a:off x="6569613" y="4308572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D48EE7F4-80AF-41C2-891D-157C14044124}"/>
                </a:ext>
              </a:extLst>
            </p:cNvPr>
            <p:cNvSpPr txBox="1"/>
            <p:nvPr/>
          </p:nvSpPr>
          <p:spPr>
            <a:xfrm>
              <a:off x="6652740" y="3191763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F8A48BB2-091C-4668-8846-E912706B01EA}"/>
                </a:ext>
              </a:extLst>
            </p:cNvPr>
            <p:cNvSpPr txBox="1"/>
            <p:nvPr/>
          </p:nvSpPr>
          <p:spPr>
            <a:xfrm>
              <a:off x="6886254" y="3358911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5B5CAD11-B901-41F1-99D5-48C7E31935E7}"/>
                </a:ext>
              </a:extLst>
            </p:cNvPr>
            <p:cNvSpPr txBox="1"/>
            <p:nvPr/>
          </p:nvSpPr>
          <p:spPr>
            <a:xfrm>
              <a:off x="5801543" y="3337149"/>
              <a:ext cx="519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Nu</a:t>
              </a:r>
            </a:p>
          </p:txBody>
        </p:sp>
        <p:cxnSp>
          <p:nvCxnSpPr>
            <p:cNvPr id="122" name="Straight Arrow Connector 121">
              <a:extLst>
                <a:ext uri="{FF2B5EF4-FFF2-40B4-BE49-F238E27FC236}">
                  <a16:creationId xmlns:a16="http://schemas.microsoft.com/office/drawing/2014/main" id="{605D6B72-08B3-4F97-9488-27CEEB2AD213}"/>
                </a:ext>
              </a:extLst>
            </p:cNvPr>
            <p:cNvCxnSpPr/>
            <p:nvPr/>
          </p:nvCxnSpPr>
          <p:spPr>
            <a:xfrm>
              <a:off x="6564319" y="3054414"/>
              <a:ext cx="93503" cy="221423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Arrow Connector 122">
              <a:extLst>
                <a:ext uri="{FF2B5EF4-FFF2-40B4-BE49-F238E27FC236}">
                  <a16:creationId xmlns:a16="http://schemas.microsoft.com/office/drawing/2014/main" id="{4F222407-0AF8-4CDC-8128-6E752396DBF5}"/>
                </a:ext>
              </a:extLst>
            </p:cNvPr>
            <p:cNvCxnSpPr/>
            <p:nvPr/>
          </p:nvCxnSpPr>
          <p:spPr>
            <a:xfrm>
              <a:off x="6492141" y="4336135"/>
              <a:ext cx="64137" cy="193128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7DC084F6-B73F-454B-AF7E-024F685CBFA8}"/>
                </a:ext>
              </a:extLst>
            </p:cNvPr>
            <p:cNvCxnSpPr/>
            <p:nvPr/>
          </p:nvCxnSpPr>
          <p:spPr>
            <a:xfrm>
              <a:off x="6386372" y="5366259"/>
              <a:ext cx="249427" cy="111324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5" name="TextBox 124"/>
          <p:cNvSpPr txBox="1"/>
          <p:nvPr/>
        </p:nvSpPr>
        <p:spPr>
          <a:xfrm>
            <a:off x="643630" y="48373"/>
            <a:ext cx="29414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Dual-reporter (RFP fusion)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296390" y="29748"/>
            <a:ext cx="65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0081F6D4-71F9-4F3B-B162-712B2CA94B8D}"/>
              </a:ext>
            </a:extLst>
          </p:cNvPr>
          <p:cNvGrpSpPr/>
          <p:nvPr/>
        </p:nvGrpSpPr>
        <p:grpSpPr>
          <a:xfrm>
            <a:off x="645222" y="349286"/>
            <a:ext cx="8659586" cy="1176877"/>
            <a:chOff x="416623" y="1871110"/>
            <a:chExt cx="8659586" cy="1176877"/>
          </a:xfrm>
        </p:grpSpPr>
        <p:grpSp>
          <p:nvGrpSpPr>
            <p:cNvPr id="128" name="Group 127"/>
            <p:cNvGrpSpPr/>
            <p:nvPr/>
          </p:nvGrpSpPr>
          <p:grpSpPr>
            <a:xfrm>
              <a:off x="421019" y="1871110"/>
              <a:ext cx="8542109" cy="384716"/>
              <a:chOff x="490704" y="3692675"/>
              <a:chExt cx="8542109" cy="490528"/>
            </a:xfrm>
          </p:grpSpPr>
          <p:cxnSp>
            <p:nvCxnSpPr>
              <p:cNvPr id="148" name="Straight Connector 147"/>
              <p:cNvCxnSpPr/>
              <p:nvPr/>
            </p:nvCxnSpPr>
            <p:spPr>
              <a:xfrm>
                <a:off x="490704" y="3929897"/>
                <a:ext cx="545194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Right Arrow 148"/>
              <p:cNvSpPr/>
              <p:nvPr/>
            </p:nvSpPr>
            <p:spPr>
              <a:xfrm>
                <a:off x="720693" y="3708760"/>
                <a:ext cx="699461" cy="474443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CMV</a:t>
                </a:r>
              </a:p>
            </p:txBody>
          </p:sp>
          <p:sp>
            <p:nvSpPr>
              <p:cNvPr id="150" name="Rectangle 149"/>
              <p:cNvSpPr/>
              <p:nvPr/>
            </p:nvSpPr>
            <p:spPr>
              <a:xfrm>
                <a:off x="1454851" y="3834016"/>
                <a:ext cx="427877" cy="220211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SP</a:t>
                </a:r>
              </a:p>
            </p:txBody>
          </p:sp>
          <p:sp>
            <p:nvSpPr>
              <p:cNvPr id="151" name="Rectangle 150"/>
              <p:cNvSpPr/>
              <p:nvPr/>
            </p:nvSpPr>
            <p:spPr>
              <a:xfrm>
                <a:off x="1883298" y="3834017"/>
                <a:ext cx="730207" cy="220210"/>
              </a:xfrm>
              <a:prstGeom prst="rect">
                <a:avLst/>
              </a:prstGeom>
              <a:solidFill>
                <a:srgbClr val="7030A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bg1"/>
                    </a:solidFill>
                  </a:rPr>
                  <a:t>gLuc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2" name="Rectangle 151"/>
              <p:cNvSpPr/>
              <p:nvPr/>
            </p:nvSpPr>
            <p:spPr>
              <a:xfrm>
                <a:off x="2626155" y="3837482"/>
                <a:ext cx="812746" cy="216745"/>
              </a:xfrm>
              <a:prstGeom prst="rect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RFP</a:t>
                </a:r>
              </a:p>
            </p:txBody>
          </p:sp>
          <p:sp>
            <p:nvSpPr>
              <p:cNvPr id="153" name="Right Arrow 152"/>
              <p:cNvSpPr/>
              <p:nvPr/>
            </p:nvSpPr>
            <p:spPr>
              <a:xfrm>
                <a:off x="3550520" y="3692675"/>
                <a:ext cx="699461" cy="474443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EF1</a:t>
                </a:r>
                <a:r>
                  <a:rPr lang="el-GR" sz="1400" b="1" dirty="0">
                    <a:solidFill>
                      <a:schemeClr val="tx1"/>
                    </a:solidFill>
                  </a:rPr>
                  <a:t>α</a:t>
                </a:r>
                <a:endParaRPr lang="en-US" sz="1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4" name="Rectangle 153"/>
              <p:cNvSpPr/>
              <p:nvPr/>
            </p:nvSpPr>
            <p:spPr>
              <a:xfrm>
                <a:off x="4278440" y="3815073"/>
                <a:ext cx="664625" cy="236019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bg1"/>
                    </a:solidFill>
                  </a:rPr>
                  <a:t>Puro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5" name="Rectangle 154"/>
              <p:cNvSpPr/>
              <p:nvPr/>
            </p:nvSpPr>
            <p:spPr>
              <a:xfrm>
                <a:off x="4971524" y="3812332"/>
                <a:ext cx="773754" cy="238760"/>
              </a:xfrm>
              <a:prstGeom prst="rect">
                <a:avLst/>
              </a:prstGeom>
              <a:solidFill>
                <a:srgbClr val="C000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Poly(A)</a:t>
                </a:r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5973816" y="3721658"/>
                <a:ext cx="3058997" cy="431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ER-Golgi-secretion</a:t>
                </a:r>
              </a:p>
            </p:txBody>
          </p:sp>
        </p:grpSp>
        <p:grpSp>
          <p:nvGrpSpPr>
            <p:cNvPr id="129" name="Group 128"/>
            <p:cNvGrpSpPr/>
            <p:nvPr/>
          </p:nvGrpSpPr>
          <p:grpSpPr>
            <a:xfrm>
              <a:off x="436949" y="2280618"/>
              <a:ext cx="8492645" cy="378426"/>
              <a:chOff x="514767" y="4287051"/>
              <a:chExt cx="8492645" cy="482507"/>
            </a:xfrm>
          </p:grpSpPr>
          <p:cxnSp>
            <p:nvCxnSpPr>
              <p:cNvPr id="139" name="Straight Connector 138"/>
              <p:cNvCxnSpPr/>
              <p:nvPr/>
            </p:nvCxnSpPr>
            <p:spPr>
              <a:xfrm>
                <a:off x="514767" y="4524273"/>
                <a:ext cx="5455873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Right Arrow 139"/>
              <p:cNvSpPr/>
              <p:nvPr/>
            </p:nvSpPr>
            <p:spPr>
              <a:xfrm>
                <a:off x="720693" y="4295115"/>
                <a:ext cx="699461" cy="474443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CMV</a:t>
                </a:r>
              </a:p>
            </p:txBody>
          </p:sp>
          <p:sp>
            <p:nvSpPr>
              <p:cNvPr id="141" name="Rectangle 140"/>
              <p:cNvSpPr/>
              <p:nvPr/>
            </p:nvSpPr>
            <p:spPr>
              <a:xfrm>
                <a:off x="1435914" y="4428393"/>
                <a:ext cx="470877" cy="219444"/>
              </a:xfrm>
              <a:prstGeom prst="rect">
                <a:avLst/>
              </a:prstGeom>
              <a:pattFill prst="pct60">
                <a:fgClr>
                  <a:schemeClr val="accent6">
                    <a:lumMod val="60000"/>
                    <a:lumOff val="40000"/>
                  </a:schemeClr>
                </a:fgClr>
                <a:bgClr>
                  <a:schemeClr val="bg1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tx1"/>
                    </a:solidFill>
                  </a:rPr>
                  <a:t>Exo</a:t>
                </a:r>
                <a:endParaRPr lang="en-US" sz="1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2" name="Rectangle 141"/>
              <p:cNvSpPr/>
              <p:nvPr/>
            </p:nvSpPr>
            <p:spPr>
              <a:xfrm>
                <a:off x="1907361" y="4428393"/>
                <a:ext cx="730207" cy="220210"/>
              </a:xfrm>
              <a:prstGeom prst="rect">
                <a:avLst/>
              </a:prstGeom>
              <a:solidFill>
                <a:srgbClr val="7030A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bg1"/>
                    </a:solidFill>
                  </a:rPr>
                  <a:t>gLuc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43" name="Rectangle 142"/>
              <p:cNvSpPr/>
              <p:nvPr/>
            </p:nvSpPr>
            <p:spPr>
              <a:xfrm>
                <a:off x="2627207" y="4428012"/>
                <a:ext cx="812746" cy="220591"/>
              </a:xfrm>
              <a:prstGeom prst="rect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RFP</a:t>
                </a:r>
              </a:p>
            </p:txBody>
          </p:sp>
          <p:sp>
            <p:nvSpPr>
              <p:cNvPr id="144" name="Right Arrow 143"/>
              <p:cNvSpPr/>
              <p:nvPr/>
            </p:nvSpPr>
            <p:spPr>
              <a:xfrm>
                <a:off x="3574583" y="4287051"/>
                <a:ext cx="699461" cy="474443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EF1</a:t>
                </a:r>
                <a:r>
                  <a:rPr lang="el-GR" sz="1400" b="1" dirty="0">
                    <a:solidFill>
                      <a:schemeClr val="tx1"/>
                    </a:solidFill>
                  </a:rPr>
                  <a:t>α</a:t>
                </a:r>
                <a:endParaRPr lang="en-US" sz="1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5" name="Rectangle 144"/>
              <p:cNvSpPr/>
              <p:nvPr/>
            </p:nvSpPr>
            <p:spPr>
              <a:xfrm>
                <a:off x="4302503" y="4409449"/>
                <a:ext cx="649133" cy="232515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bg1"/>
                    </a:solidFill>
                  </a:rPr>
                  <a:t>Puro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46" name="Rectangle 145"/>
              <p:cNvSpPr/>
              <p:nvPr/>
            </p:nvSpPr>
            <p:spPr>
              <a:xfrm>
                <a:off x="4977708" y="4409314"/>
                <a:ext cx="747682" cy="237950"/>
              </a:xfrm>
              <a:prstGeom prst="rect">
                <a:avLst/>
              </a:prstGeom>
              <a:solidFill>
                <a:srgbClr val="C000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Poly(A)</a:t>
                </a: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5976409" y="4330900"/>
                <a:ext cx="3031003" cy="4316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Exosome-secretion</a:t>
                </a:r>
              </a:p>
            </p:txBody>
          </p:sp>
        </p:grpSp>
        <p:grpSp>
          <p:nvGrpSpPr>
            <p:cNvPr id="130" name="Group 129"/>
            <p:cNvGrpSpPr/>
            <p:nvPr/>
          </p:nvGrpSpPr>
          <p:grpSpPr>
            <a:xfrm>
              <a:off x="416623" y="2663271"/>
              <a:ext cx="8659586" cy="384716"/>
              <a:chOff x="486308" y="4850967"/>
              <a:chExt cx="8659586" cy="490528"/>
            </a:xfrm>
          </p:grpSpPr>
          <p:cxnSp>
            <p:nvCxnSpPr>
              <p:cNvPr id="131" name="Straight Connector 130"/>
              <p:cNvCxnSpPr/>
              <p:nvPr/>
            </p:nvCxnSpPr>
            <p:spPr>
              <a:xfrm>
                <a:off x="486308" y="5088189"/>
                <a:ext cx="5493662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Right Arrow 131"/>
              <p:cNvSpPr/>
              <p:nvPr/>
            </p:nvSpPr>
            <p:spPr>
              <a:xfrm>
                <a:off x="716297" y="4867052"/>
                <a:ext cx="699461" cy="474443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CMV</a:t>
                </a:r>
              </a:p>
            </p:txBody>
          </p:sp>
          <p:sp>
            <p:nvSpPr>
              <p:cNvPr id="133" name="Rectangle 132"/>
              <p:cNvSpPr/>
              <p:nvPr/>
            </p:nvSpPr>
            <p:spPr>
              <a:xfrm>
                <a:off x="1953852" y="4992309"/>
                <a:ext cx="730207" cy="220210"/>
              </a:xfrm>
              <a:prstGeom prst="rect">
                <a:avLst/>
              </a:prstGeom>
              <a:solidFill>
                <a:srgbClr val="7030A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bg1"/>
                    </a:solidFill>
                  </a:rPr>
                  <a:t>gLuc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4" name="Rectangle 133"/>
              <p:cNvSpPr/>
              <p:nvPr/>
            </p:nvSpPr>
            <p:spPr>
              <a:xfrm>
                <a:off x="2658708" y="4994231"/>
                <a:ext cx="812746" cy="218288"/>
              </a:xfrm>
              <a:prstGeom prst="rect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RFP</a:t>
                </a:r>
              </a:p>
            </p:txBody>
          </p:sp>
          <p:sp>
            <p:nvSpPr>
              <p:cNvPr id="135" name="Right Arrow 134"/>
              <p:cNvSpPr/>
              <p:nvPr/>
            </p:nvSpPr>
            <p:spPr>
              <a:xfrm>
                <a:off x="3621074" y="4850967"/>
                <a:ext cx="699461" cy="474443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tx1"/>
                    </a:solidFill>
                  </a:rPr>
                  <a:t>EF1</a:t>
                </a:r>
                <a:r>
                  <a:rPr lang="el-GR" sz="1400" b="1" dirty="0">
                    <a:solidFill>
                      <a:schemeClr val="tx1"/>
                    </a:solidFill>
                  </a:rPr>
                  <a:t>α</a:t>
                </a:r>
                <a:endParaRPr lang="en-US" sz="1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36" name="Rectangle 135"/>
              <p:cNvSpPr/>
              <p:nvPr/>
            </p:nvSpPr>
            <p:spPr>
              <a:xfrm>
                <a:off x="4348994" y="4973366"/>
                <a:ext cx="620674" cy="227074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 err="1">
                    <a:solidFill>
                      <a:schemeClr val="bg1"/>
                    </a:solidFill>
                  </a:rPr>
                  <a:t>Puro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7" name="Rectangle 136"/>
              <p:cNvSpPr/>
              <p:nvPr/>
            </p:nvSpPr>
            <p:spPr>
              <a:xfrm>
                <a:off x="5011162" y="4973366"/>
                <a:ext cx="809066" cy="225649"/>
              </a:xfrm>
              <a:prstGeom prst="rect">
                <a:avLst/>
              </a:prstGeom>
              <a:solidFill>
                <a:srgbClr val="C0000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Poly(A)</a:t>
                </a: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5968156" y="4899600"/>
                <a:ext cx="3177738" cy="431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No-secretion (cytosolic protein)</a:t>
                </a:r>
              </a:p>
            </p:txBody>
          </p:sp>
        </p:grpSp>
      </p:grp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8FD7CB39-73D1-43D5-8274-FC058707A0C5}"/>
              </a:ext>
            </a:extLst>
          </p:cNvPr>
          <p:cNvGrpSpPr/>
          <p:nvPr/>
        </p:nvGrpSpPr>
        <p:grpSpPr>
          <a:xfrm>
            <a:off x="6991661" y="3475231"/>
            <a:ext cx="1656236" cy="1523382"/>
            <a:chOff x="6653045" y="1308578"/>
            <a:chExt cx="3394724" cy="2390775"/>
          </a:xfrm>
        </p:grpSpPr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93E6BF27-4C71-4C32-BA87-CAEC2352892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730411" y="1308578"/>
              <a:ext cx="3317358" cy="2390775"/>
            </a:xfrm>
            <a:prstGeom prst="rect">
              <a:avLst/>
            </a:prstGeom>
          </p:spPr>
        </p:pic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10050D02-68A0-43FA-951A-C574D9AF9778}"/>
                </a:ext>
              </a:extLst>
            </p:cNvPr>
            <p:cNvCxnSpPr/>
            <p:nvPr/>
          </p:nvCxnSpPr>
          <p:spPr>
            <a:xfrm>
              <a:off x="6653045" y="1343921"/>
              <a:ext cx="0" cy="2301765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DE4296E6-9298-4F5A-A6A3-20CB2056278C}"/>
                </a:ext>
              </a:extLst>
            </p:cNvPr>
            <p:cNvCxnSpPr/>
            <p:nvPr/>
          </p:nvCxnSpPr>
          <p:spPr>
            <a:xfrm>
              <a:off x="9999908" y="3653305"/>
              <a:ext cx="8645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03DBD29A-133A-4817-8B7F-024EEF654C99}"/>
                </a:ext>
              </a:extLst>
            </p:cNvPr>
            <p:cNvCxnSpPr/>
            <p:nvPr/>
          </p:nvCxnSpPr>
          <p:spPr>
            <a:xfrm flipH="1">
              <a:off x="6655298" y="3642673"/>
              <a:ext cx="3347947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8" name="Left Bracket 177">
            <a:extLst>
              <a:ext uri="{FF2B5EF4-FFF2-40B4-BE49-F238E27FC236}">
                <a16:creationId xmlns:a16="http://schemas.microsoft.com/office/drawing/2014/main" id="{E9A7E13A-1B93-4BBA-A5F9-C01A344913A9}"/>
              </a:ext>
            </a:extLst>
          </p:cNvPr>
          <p:cNvSpPr/>
          <p:nvPr/>
        </p:nvSpPr>
        <p:spPr>
          <a:xfrm rot="5400000">
            <a:off x="7582004" y="4491891"/>
            <a:ext cx="29132" cy="529122"/>
          </a:xfrm>
          <a:prstGeom prst="leftBracket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1ABA9515-7827-4610-AEE7-94EC00EA0C2B}"/>
              </a:ext>
            </a:extLst>
          </p:cNvPr>
          <p:cNvSpPr txBox="1"/>
          <p:nvPr/>
        </p:nvSpPr>
        <p:spPr>
          <a:xfrm>
            <a:off x="7398937" y="4527117"/>
            <a:ext cx="358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x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DFF2168C-D686-4A2A-89F8-44817F453483}"/>
              </a:ext>
            </a:extLst>
          </p:cNvPr>
          <p:cNvSpPr txBox="1"/>
          <p:nvPr/>
        </p:nvSpPr>
        <p:spPr>
          <a:xfrm>
            <a:off x="7131522" y="4930071"/>
            <a:ext cx="577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BS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5EB4EE10-53CB-4FBC-AA0F-548DF0B696D0}"/>
              </a:ext>
            </a:extLst>
          </p:cNvPr>
          <p:cNvSpPr txBox="1"/>
          <p:nvPr/>
        </p:nvSpPr>
        <p:spPr>
          <a:xfrm>
            <a:off x="7561232" y="4930071"/>
            <a:ext cx="6847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ontrol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397E43E1-1773-4060-82AF-90628941B1E6}"/>
              </a:ext>
            </a:extLst>
          </p:cNvPr>
          <p:cNvSpPr txBox="1"/>
          <p:nvPr/>
        </p:nvSpPr>
        <p:spPr>
          <a:xfrm>
            <a:off x="7983143" y="4930071"/>
            <a:ext cx="8474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Exo-</a:t>
            </a:r>
          </a:p>
          <a:p>
            <a:pPr algn="ctr"/>
            <a:r>
              <a:rPr lang="en-US" sz="1200" b="1" dirty="0" err="1"/>
              <a:t>gLuc</a:t>
            </a:r>
            <a:r>
              <a:rPr lang="en-US" sz="1200" b="1" dirty="0"/>
              <a:t>-RFP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1FD785A6-2010-4376-B131-0DCA9BF5453D}"/>
              </a:ext>
            </a:extLst>
          </p:cNvPr>
          <p:cNvSpPr txBox="1"/>
          <p:nvPr/>
        </p:nvSpPr>
        <p:spPr>
          <a:xfrm>
            <a:off x="8152353" y="3505447"/>
            <a:ext cx="6058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.2x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C7591F8F-A324-45E7-9CC0-F0D4D7C1AB46}"/>
              </a:ext>
            </a:extLst>
          </p:cNvPr>
          <p:cNvSpPr txBox="1"/>
          <p:nvPr/>
        </p:nvSpPr>
        <p:spPr>
          <a:xfrm>
            <a:off x="6806192" y="4817156"/>
            <a:ext cx="207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0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D16503E8-09F6-4F4A-9B0A-15CE9296592C}"/>
              </a:ext>
            </a:extLst>
          </p:cNvPr>
          <p:cNvSpPr txBox="1"/>
          <p:nvPr/>
        </p:nvSpPr>
        <p:spPr>
          <a:xfrm>
            <a:off x="6528114" y="4594868"/>
            <a:ext cx="529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2E+4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E1FFF67F-8D1E-4EE9-B8AC-1F38D8C7D2B8}"/>
              </a:ext>
            </a:extLst>
          </p:cNvPr>
          <p:cNvSpPr txBox="1"/>
          <p:nvPr/>
        </p:nvSpPr>
        <p:spPr>
          <a:xfrm>
            <a:off x="6510064" y="4369037"/>
            <a:ext cx="547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4E+4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FDCD950E-1EC5-4FF0-A3ED-9A973E99F7E5}"/>
              </a:ext>
            </a:extLst>
          </p:cNvPr>
          <p:cNvSpPr txBox="1"/>
          <p:nvPr/>
        </p:nvSpPr>
        <p:spPr>
          <a:xfrm>
            <a:off x="6550221" y="3691538"/>
            <a:ext cx="5070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1E+5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11C4E4E5-E174-4F47-9EF6-C7A4ABFC628D}"/>
              </a:ext>
            </a:extLst>
          </p:cNvPr>
          <p:cNvSpPr txBox="1"/>
          <p:nvPr/>
        </p:nvSpPr>
        <p:spPr>
          <a:xfrm>
            <a:off x="6368613" y="3445812"/>
            <a:ext cx="69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1.2E+5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FBAC375C-4803-4ADA-9653-DC098E5F9447}"/>
              </a:ext>
            </a:extLst>
          </p:cNvPr>
          <p:cNvSpPr txBox="1"/>
          <p:nvPr/>
        </p:nvSpPr>
        <p:spPr>
          <a:xfrm rot="16200000">
            <a:off x="5805019" y="3828101"/>
            <a:ext cx="1236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ight Units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4BE535B8-CE6D-45AD-A43D-976C4CC23271}"/>
              </a:ext>
            </a:extLst>
          </p:cNvPr>
          <p:cNvSpPr txBox="1"/>
          <p:nvPr/>
        </p:nvSpPr>
        <p:spPr>
          <a:xfrm>
            <a:off x="6333232" y="4143419"/>
            <a:ext cx="713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6E+4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2F1FF60D-CB8C-450D-9B09-060235778560}"/>
              </a:ext>
            </a:extLst>
          </p:cNvPr>
          <p:cNvSpPr txBox="1"/>
          <p:nvPr/>
        </p:nvSpPr>
        <p:spPr>
          <a:xfrm>
            <a:off x="6196753" y="3926008"/>
            <a:ext cx="849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8E+4</a:t>
            </a:r>
          </a:p>
        </p:txBody>
      </p:sp>
      <p:grpSp>
        <p:nvGrpSpPr>
          <p:cNvPr id="199" name="Group 198"/>
          <p:cNvGrpSpPr/>
          <p:nvPr/>
        </p:nvGrpSpPr>
        <p:grpSpPr>
          <a:xfrm>
            <a:off x="8967503" y="3524905"/>
            <a:ext cx="2930583" cy="1892661"/>
            <a:chOff x="9258452" y="4112741"/>
            <a:chExt cx="2531346" cy="1353883"/>
          </a:xfrm>
        </p:grpSpPr>
        <p:pic>
          <p:nvPicPr>
            <p:cNvPr id="192" name="Picture 19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754818" y="4199315"/>
              <a:ext cx="1659080" cy="952643"/>
            </a:xfrm>
            <a:prstGeom prst="rect">
              <a:avLst/>
            </a:prstGeom>
          </p:spPr>
        </p:pic>
        <p:sp>
          <p:nvSpPr>
            <p:cNvPr id="193" name="TextBox 192"/>
            <p:cNvSpPr txBox="1"/>
            <p:nvPr/>
          </p:nvSpPr>
          <p:spPr>
            <a:xfrm>
              <a:off x="9258452" y="4112741"/>
              <a:ext cx="594349" cy="1981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.52E9</a:t>
              </a:r>
            </a:p>
          </p:txBody>
        </p:sp>
        <p:sp>
          <p:nvSpPr>
            <p:cNvPr id="194" name="Rectangle 193"/>
            <p:cNvSpPr/>
            <p:nvPr/>
          </p:nvSpPr>
          <p:spPr>
            <a:xfrm>
              <a:off x="10006922" y="4297101"/>
              <a:ext cx="1566611" cy="2201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0" i="0" u="none" strike="noStrike" baseline="0" dirty="0"/>
                <a:t>Mode: 79 +/- 6.0 nm</a:t>
              </a:r>
            </a:p>
          </p:txBody>
        </p:sp>
        <p:sp>
          <p:nvSpPr>
            <p:cNvPr id="195" name="TextBox 194"/>
            <p:cNvSpPr txBox="1"/>
            <p:nvPr/>
          </p:nvSpPr>
          <p:spPr>
            <a:xfrm rot="16200000">
              <a:off x="9134606" y="4477386"/>
              <a:ext cx="902271" cy="2658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Particles/mL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10144148" y="4524610"/>
              <a:ext cx="1241331" cy="3302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/>
                <a:t>Exo</a:t>
              </a:r>
              <a:r>
                <a:rPr lang="en-US" sz="1200" b="1" dirty="0"/>
                <a:t>-</a:t>
              </a:r>
              <a:r>
                <a:rPr lang="en-US" sz="1200" b="1" dirty="0" err="1"/>
                <a:t>gLuc</a:t>
              </a:r>
              <a:r>
                <a:rPr lang="en-US" sz="1200" b="1" dirty="0"/>
                <a:t>-RFP</a:t>
              </a:r>
            </a:p>
            <a:p>
              <a:pPr algn="ctr"/>
              <a:r>
                <a:rPr lang="en-US" sz="1200" b="1" dirty="0"/>
                <a:t>Exosome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10357132" y="5246461"/>
              <a:ext cx="842555" cy="220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Size (nm)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9666566" y="5108778"/>
              <a:ext cx="2123232" cy="187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0       200       400      600      800     1000   </a:t>
              </a:r>
            </a:p>
          </p:txBody>
        </p:sp>
      </p:grpSp>
      <p:grpSp>
        <p:nvGrpSpPr>
          <p:cNvPr id="200" name="Group 199"/>
          <p:cNvGrpSpPr/>
          <p:nvPr/>
        </p:nvGrpSpPr>
        <p:grpSpPr>
          <a:xfrm>
            <a:off x="6766487" y="1688958"/>
            <a:ext cx="1767912" cy="1609408"/>
            <a:chOff x="6207114" y="969546"/>
            <a:chExt cx="1239719" cy="1321515"/>
          </a:xfrm>
        </p:grpSpPr>
        <p:pic>
          <p:nvPicPr>
            <p:cNvPr id="201" name="Picture 200"/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3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207114" y="969546"/>
              <a:ext cx="1239719" cy="1288200"/>
            </a:xfrm>
            <a:prstGeom prst="rect">
              <a:avLst/>
            </a:prstGeom>
          </p:spPr>
        </p:pic>
        <p:sp>
          <p:nvSpPr>
            <p:cNvPr id="202" name="TextBox 201"/>
            <p:cNvSpPr txBox="1"/>
            <p:nvPr/>
          </p:nvSpPr>
          <p:spPr>
            <a:xfrm>
              <a:off x="6335519" y="1829396"/>
              <a:ext cx="10474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</a:rPr>
                <a:t>Exo-</a:t>
              </a:r>
              <a:r>
                <a:rPr lang="en-US" sz="1200" b="1" dirty="0" err="1">
                  <a:solidFill>
                    <a:schemeClr val="bg1"/>
                  </a:solidFill>
                </a:rPr>
                <a:t>gLuc</a:t>
              </a:r>
              <a:r>
                <a:rPr lang="en-US" sz="1200" b="1" dirty="0">
                  <a:solidFill>
                    <a:schemeClr val="bg1"/>
                  </a:solidFill>
                </a:rPr>
                <a:t>-RFP</a:t>
              </a:r>
            </a:p>
            <a:p>
              <a:pPr algn="ctr"/>
              <a:r>
                <a:rPr lang="en-US" sz="1200" b="1" dirty="0">
                  <a:solidFill>
                    <a:schemeClr val="bg1"/>
                  </a:solidFill>
                </a:rPr>
                <a:t>exosome</a:t>
              </a:r>
            </a:p>
          </p:txBody>
        </p:sp>
        <p:cxnSp>
          <p:nvCxnSpPr>
            <p:cNvPr id="203" name="Straight Arrow Connector 202"/>
            <p:cNvCxnSpPr/>
            <p:nvPr/>
          </p:nvCxnSpPr>
          <p:spPr>
            <a:xfrm flipV="1">
              <a:off x="6729663" y="1503220"/>
              <a:ext cx="112460" cy="176214"/>
            </a:xfrm>
            <a:prstGeom prst="straightConnector1">
              <a:avLst/>
            </a:prstGeom>
            <a:ln w="222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/>
            <p:cNvCxnSpPr/>
            <p:nvPr/>
          </p:nvCxnSpPr>
          <p:spPr>
            <a:xfrm>
              <a:off x="6264121" y="1042343"/>
              <a:ext cx="321534" cy="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6" name="TextBox 205"/>
          <p:cNvSpPr txBox="1"/>
          <p:nvPr/>
        </p:nvSpPr>
        <p:spPr>
          <a:xfrm>
            <a:off x="6152904" y="1529795"/>
            <a:ext cx="65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C</a:t>
            </a:r>
            <a:endParaRPr lang="en-US" sz="2000" b="1" dirty="0"/>
          </a:p>
        </p:txBody>
      </p:sp>
      <p:sp>
        <p:nvSpPr>
          <p:cNvPr id="207" name="TextBox 206"/>
          <p:cNvSpPr txBox="1"/>
          <p:nvPr/>
        </p:nvSpPr>
        <p:spPr>
          <a:xfrm>
            <a:off x="6196447" y="3217082"/>
            <a:ext cx="65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D</a:t>
            </a:r>
            <a:endParaRPr lang="en-US" sz="2000" b="1" dirty="0"/>
          </a:p>
        </p:txBody>
      </p:sp>
      <p:sp>
        <p:nvSpPr>
          <p:cNvPr id="208" name="TextBox 207"/>
          <p:cNvSpPr txBox="1"/>
          <p:nvPr/>
        </p:nvSpPr>
        <p:spPr>
          <a:xfrm>
            <a:off x="8874333" y="3217082"/>
            <a:ext cx="651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E</a:t>
            </a:r>
            <a:endParaRPr lang="en-US" sz="2000" b="1" dirty="0"/>
          </a:p>
        </p:txBody>
      </p:sp>
      <p:sp>
        <p:nvSpPr>
          <p:cNvPr id="209" name="Rectangle 208"/>
          <p:cNvSpPr/>
          <p:nvPr/>
        </p:nvSpPr>
        <p:spPr>
          <a:xfrm>
            <a:off x="391885" y="5376599"/>
            <a:ext cx="1161505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</a:t>
            </a:r>
            <a:r>
              <a:rPr lang="en-US" sz="1400" b="1" dirty="0" smtClean="0"/>
              <a:t>S1</a:t>
            </a:r>
            <a:r>
              <a:rPr lang="en-US" sz="1400" b="1" dirty="0"/>
              <a:t>. Construction of dual-reporters and their characterizations.</a:t>
            </a:r>
            <a:r>
              <a:rPr lang="en-US" sz="1400" dirty="0"/>
              <a:t> </a:t>
            </a:r>
            <a:r>
              <a:rPr lang="en-US" sz="1400" dirty="0" smtClean="0"/>
              <a:t>(</a:t>
            </a:r>
            <a:r>
              <a:rPr lang="en-US" sz="1400" b="1" dirty="0" smtClean="0"/>
              <a:t>A</a:t>
            </a:r>
            <a:r>
              <a:rPr lang="en-US" sz="1400" dirty="0" smtClean="0"/>
              <a:t>) Schematic </a:t>
            </a:r>
            <a:r>
              <a:rPr lang="en-US" sz="1400" dirty="0"/>
              <a:t>illustration of key features of the dual-reporters, depicting dual-reporters of </a:t>
            </a:r>
            <a:r>
              <a:rPr lang="en-US" sz="1400" dirty="0" err="1"/>
              <a:t>gLuc</a:t>
            </a:r>
            <a:r>
              <a:rPr lang="en-US" sz="1400" dirty="0"/>
              <a:t> fused with RFP, under the control of CMV </a:t>
            </a:r>
            <a:r>
              <a:rPr lang="en-US" sz="1400" dirty="0" smtClean="0"/>
              <a:t>promoter. (</a:t>
            </a:r>
            <a:r>
              <a:rPr lang="en-US" sz="1400" b="1" dirty="0" smtClean="0"/>
              <a:t>B</a:t>
            </a:r>
            <a:r>
              <a:rPr lang="en-US" sz="1400" dirty="0" smtClean="0"/>
              <a:t>) Subcellular </a:t>
            </a:r>
            <a:r>
              <a:rPr lang="en-US" sz="1400" dirty="0"/>
              <a:t>localization of different secretory pathways of either exosome- or ER-Golgi-mediated secretion or non-specific secretion in 293T cells was </a:t>
            </a:r>
            <a:r>
              <a:rPr lang="en-US" sz="1400" dirty="0" smtClean="0"/>
              <a:t>recorded. (</a:t>
            </a:r>
            <a:r>
              <a:rPr lang="en-US" sz="1400" b="1" dirty="0" smtClean="0"/>
              <a:t>C</a:t>
            </a:r>
            <a:r>
              <a:rPr lang="en-US" sz="1400" dirty="0" smtClean="0"/>
              <a:t>) Confocal </a:t>
            </a:r>
            <a:r>
              <a:rPr lang="en-US" sz="1400" dirty="0"/>
              <a:t>image of isolated exosomes from </a:t>
            </a:r>
            <a:r>
              <a:rPr lang="en-US" sz="1400" dirty="0" err="1"/>
              <a:t>Exo</a:t>
            </a:r>
            <a:r>
              <a:rPr lang="en-US" sz="1400" dirty="0"/>
              <a:t>-</a:t>
            </a:r>
            <a:r>
              <a:rPr lang="en-US" sz="1400" dirty="0" err="1"/>
              <a:t>gLuc</a:t>
            </a:r>
            <a:r>
              <a:rPr lang="en-US" sz="1400" dirty="0"/>
              <a:t>-RFP transfected 293T </a:t>
            </a:r>
            <a:r>
              <a:rPr lang="en-US" sz="1400" dirty="0" smtClean="0"/>
              <a:t>cells. </a:t>
            </a:r>
            <a:r>
              <a:rPr lang="en-US" sz="1400" dirty="0" smtClean="0"/>
              <a:t>(</a:t>
            </a:r>
            <a:r>
              <a:rPr lang="en-US" sz="1400" b="1" dirty="0" smtClean="0"/>
              <a:t>D</a:t>
            </a:r>
            <a:r>
              <a:rPr lang="en-US" sz="1400" dirty="0" smtClean="0"/>
              <a:t>) </a:t>
            </a:r>
            <a:r>
              <a:rPr lang="en-US" sz="1400" dirty="0" err="1" smtClean="0"/>
              <a:t>Gaussia</a:t>
            </a:r>
            <a:r>
              <a:rPr lang="en-US" sz="1400" dirty="0" smtClean="0"/>
              <a:t> luciferase </a:t>
            </a:r>
            <a:r>
              <a:rPr lang="en-US" sz="1400" dirty="0"/>
              <a:t>activity was measured in PBS as well as in exosomes isolated from non-modified control, and </a:t>
            </a:r>
            <a:r>
              <a:rPr lang="en-US" sz="1400" dirty="0" err="1"/>
              <a:t>Exo</a:t>
            </a:r>
            <a:r>
              <a:rPr lang="en-US" sz="1400" dirty="0"/>
              <a:t>-</a:t>
            </a:r>
            <a:r>
              <a:rPr lang="en-US" sz="1400" dirty="0" err="1"/>
              <a:t>gLuc</a:t>
            </a:r>
            <a:r>
              <a:rPr lang="en-US" sz="1400" dirty="0"/>
              <a:t>-RFP transfected cells. Data were averages of two </a:t>
            </a:r>
            <a:r>
              <a:rPr lang="en-US" sz="1400" dirty="0" smtClean="0"/>
              <a:t>independent </a:t>
            </a:r>
            <a:r>
              <a:rPr lang="en-US" sz="1400" dirty="0" smtClean="0"/>
              <a:t>exosome preparations </a:t>
            </a:r>
            <a:r>
              <a:rPr lang="en-US" sz="1400" dirty="0"/>
              <a:t>(n = </a:t>
            </a:r>
            <a:r>
              <a:rPr lang="en-US" sz="1400" dirty="0" smtClean="0"/>
              <a:t>2). (</a:t>
            </a:r>
            <a:r>
              <a:rPr lang="en-US" sz="1400" b="1" dirty="0" smtClean="0"/>
              <a:t>E</a:t>
            </a:r>
            <a:r>
              <a:rPr lang="en-US" sz="1400" dirty="0" smtClean="0"/>
              <a:t>) Nanoparticle </a:t>
            </a:r>
            <a:r>
              <a:rPr lang="en-US" sz="1400" dirty="0"/>
              <a:t>tracking analysis shows the vesicle size and distribution of exosomes isolated from conditioned medium of </a:t>
            </a:r>
            <a:r>
              <a:rPr lang="en-US" sz="1400" dirty="0" err="1"/>
              <a:t>Exo</a:t>
            </a:r>
            <a:r>
              <a:rPr lang="en-US" sz="1400" dirty="0"/>
              <a:t>-</a:t>
            </a:r>
            <a:r>
              <a:rPr lang="en-US" sz="1400" dirty="0" err="1"/>
              <a:t>gLuc</a:t>
            </a:r>
            <a:r>
              <a:rPr lang="en-US" sz="1400" dirty="0"/>
              <a:t>-RFP transfected </a:t>
            </a:r>
            <a:r>
              <a:rPr lang="en-US" sz="1400" dirty="0" smtClean="0"/>
              <a:t>cells.  </a:t>
            </a:r>
            <a:endParaRPr lang="en-US" sz="1400" dirty="0"/>
          </a:p>
        </p:txBody>
      </p:sp>
      <p:sp>
        <p:nvSpPr>
          <p:cNvPr id="210" name="TextBox 209"/>
          <p:cNvSpPr txBox="1"/>
          <p:nvPr/>
        </p:nvSpPr>
        <p:spPr>
          <a:xfrm>
            <a:off x="10232571" y="87086"/>
            <a:ext cx="2020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ure S1</a:t>
            </a:r>
            <a:endParaRPr lang="en-US" sz="1400" dirty="0"/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81499943-40C0-4EE3-8F64-9F4B834651AF}"/>
              </a:ext>
            </a:extLst>
          </p:cNvPr>
          <p:cNvSpPr txBox="1"/>
          <p:nvPr/>
        </p:nvSpPr>
        <p:spPr>
          <a:xfrm>
            <a:off x="6813464" y="1795668"/>
            <a:ext cx="759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</a:rPr>
              <a:t>10 µm</a:t>
            </a:r>
          </a:p>
        </p:txBody>
      </p:sp>
    </p:spTree>
    <p:extLst>
      <p:ext uri="{BB962C8B-B14F-4D97-AF65-F5344CB8AC3E}">
        <p14:creationId xmlns:p14="http://schemas.microsoft.com/office/powerpoint/2010/main" val="2557479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256</Words>
  <Application>Microsoft Office PowerPoint</Application>
  <PresentationFormat>Widescreen</PresentationFormat>
  <Paragraphs>8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anta Clar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UTechSupport</dc:creator>
  <cp:lastModifiedBy>SCUTechSupport</cp:lastModifiedBy>
  <cp:revision>9</cp:revision>
  <dcterms:created xsi:type="dcterms:W3CDTF">2023-08-11T01:48:46Z</dcterms:created>
  <dcterms:modified xsi:type="dcterms:W3CDTF">2023-08-18T18:57:06Z</dcterms:modified>
</cp:coreProperties>
</file>